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7" r:id="rId2"/>
    <p:sldId id="258" r:id="rId3"/>
    <p:sldId id="259" r:id="rId4"/>
    <p:sldId id="260" r:id="rId5"/>
    <p:sldId id="261" r:id="rId6"/>
    <p:sldId id="262" r:id="rId7"/>
  </p:sldIdLst>
  <p:sldSz cx="12192000" cy="78644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688" userDrawn="1">
          <p15:clr>
            <a:srgbClr val="A4A3A4"/>
          </p15:clr>
        </p15:guide>
        <p15:guide id="2" pos="69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701"/>
  </p:normalViewPr>
  <p:slideViewPr>
    <p:cSldViewPr snapToGrid="0">
      <p:cViewPr>
        <p:scale>
          <a:sx n="80" d="100"/>
          <a:sy n="80" d="100"/>
        </p:scale>
        <p:origin x="1068" y="408"/>
      </p:cViewPr>
      <p:guideLst>
        <p:guide orient="horz" pos="3688"/>
        <p:guide pos="69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287080"/>
            <a:ext cx="10363200" cy="2738002"/>
          </a:xfrm>
        </p:spPr>
        <p:txBody>
          <a:bodyPr anchor="b"/>
          <a:lstStyle>
            <a:lvl1pPr algn="ctr">
              <a:defRPr sz="688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130671"/>
            <a:ext cx="9144000" cy="1898760"/>
          </a:xfrm>
        </p:spPr>
        <p:txBody>
          <a:bodyPr/>
          <a:lstStyle>
            <a:lvl1pPr marL="0" indent="0" algn="ctr">
              <a:buNone/>
              <a:defRPr sz="2752"/>
            </a:lvl1pPr>
            <a:lvl2pPr marL="524317" indent="0" algn="ctr">
              <a:buNone/>
              <a:defRPr sz="2294"/>
            </a:lvl2pPr>
            <a:lvl3pPr marL="1048634" indent="0" algn="ctr">
              <a:buNone/>
              <a:defRPr sz="2064"/>
            </a:lvl3pPr>
            <a:lvl4pPr marL="1572951" indent="0" algn="ctr">
              <a:buNone/>
              <a:defRPr sz="1835"/>
            </a:lvl4pPr>
            <a:lvl5pPr marL="2097268" indent="0" algn="ctr">
              <a:buNone/>
              <a:defRPr sz="1835"/>
            </a:lvl5pPr>
            <a:lvl6pPr marL="2621585" indent="0" algn="ctr">
              <a:buNone/>
              <a:defRPr sz="1835"/>
            </a:lvl6pPr>
            <a:lvl7pPr marL="3145902" indent="0" algn="ctr">
              <a:buNone/>
              <a:defRPr sz="1835"/>
            </a:lvl7pPr>
            <a:lvl8pPr marL="3670219" indent="0" algn="ctr">
              <a:buNone/>
              <a:defRPr sz="1835"/>
            </a:lvl8pPr>
            <a:lvl9pPr marL="4194536" indent="0" algn="ctr">
              <a:buNone/>
              <a:defRPr sz="1835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7CCDA-9449-5E45-AB41-756E31D23B49}" type="datetimeFigureOut">
              <a:rPr lang="en-US" smtClean="0"/>
              <a:t>5/3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4E55C-4A9F-5647-B041-27313B3B5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05952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7CCDA-9449-5E45-AB41-756E31D23B49}" type="datetimeFigureOut">
              <a:rPr lang="en-US" smtClean="0"/>
              <a:t>5/3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4E55C-4A9F-5647-B041-27313B3B5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5265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18710"/>
            <a:ext cx="2628900" cy="666477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18710"/>
            <a:ext cx="7734300" cy="666477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7CCDA-9449-5E45-AB41-756E31D23B49}" type="datetimeFigureOut">
              <a:rPr lang="en-US" smtClean="0"/>
              <a:t>5/3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4E55C-4A9F-5647-B041-27313B3B5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45163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7CCDA-9449-5E45-AB41-756E31D23B49}" type="datetimeFigureOut">
              <a:rPr lang="en-US" smtClean="0"/>
              <a:t>5/3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4E55C-4A9F-5647-B041-27313B3B5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17643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960659"/>
            <a:ext cx="10515600" cy="3271403"/>
          </a:xfrm>
        </p:spPr>
        <p:txBody>
          <a:bodyPr anchor="b"/>
          <a:lstStyle>
            <a:lvl1pPr>
              <a:defRPr sz="688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5263011"/>
            <a:ext cx="10515600" cy="1720353"/>
          </a:xfrm>
        </p:spPr>
        <p:txBody>
          <a:bodyPr/>
          <a:lstStyle>
            <a:lvl1pPr marL="0" indent="0">
              <a:buNone/>
              <a:defRPr sz="2752">
                <a:solidFill>
                  <a:schemeClr val="tx1">
                    <a:tint val="82000"/>
                  </a:schemeClr>
                </a:solidFill>
              </a:defRPr>
            </a:lvl1pPr>
            <a:lvl2pPr marL="524317" indent="0">
              <a:buNone/>
              <a:defRPr sz="2294">
                <a:solidFill>
                  <a:schemeClr val="tx1">
                    <a:tint val="82000"/>
                  </a:schemeClr>
                </a:solidFill>
              </a:defRPr>
            </a:lvl2pPr>
            <a:lvl3pPr marL="1048634" indent="0">
              <a:buNone/>
              <a:defRPr sz="2064">
                <a:solidFill>
                  <a:schemeClr val="tx1">
                    <a:tint val="82000"/>
                  </a:schemeClr>
                </a:solidFill>
              </a:defRPr>
            </a:lvl3pPr>
            <a:lvl4pPr marL="1572951" indent="0">
              <a:buNone/>
              <a:defRPr sz="1835">
                <a:solidFill>
                  <a:schemeClr val="tx1">
                    <a:tint val="82000"/>
                  </a:schemeClr>
                </a:solidFill>
              </a:defRPr>
            </a:lvl4pPr>
            <a:lvl5pPr marL="2097268" indent="0">
              <a:buNone/>
              <a:defRPr sz="1835">
                <a:solidFill>
                  <a:schemeClr val="tx1">
                    <a:tint val="82000"/>
                  </a:schemeClr>
                </a:solidFill>
              </a:defRPr>
            </a:lvl5pPr>
            <a:lvl6pPr marL="2621585" indent="0">
              <a:buNone/>
              <a:defRPr sz="1835">
                <a:solidFill>
                  <a:schemeClr val="tx1">
                    <a:tint val="82000"/>
                  </a:schemeClr>
                </a:solidFill>
              </a:defRPr>
            </a:lvl6pPr>
            <a:lvl7pPr marL="3145902" indent="0">
              <a:buNone/>
              <a:defRPr sz="1835">
                <a:solidFill>
                  <a:schemeClr val="tx1">
                    <a:tint val="82000"/>
                  </a:schemeClr>
                </a:solidFill>
              </a:defRPr>
            </a:lvl7pPr>
            <a:lvl8pPr marL="3670219" indent="0">
              <a:buNone/>
              <a:defRPr sz="1835">
                <a:solidFill>
                  <a:schemeClr val="tx1">
                    <a:tint val="82000"/>
                  </a:schemeClr>
                </a:solidFill>
              </a:defRPr>
            </a:lvl8pPr>
            <a:lvl9pPr marL="4194536" indent="0">
              <a:buNone/>
              <a:defRPr sz="1835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7CCDA-9449-5E45-AB41-756E31D23B49}" type="datetimeFigureOut">
              <a:rPr lang="en-US" smtClean="0"/>
              <a:t>5/3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4E55C-4A9F-5647-B041-27313B3B5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32061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093552"/>
            <a:ext cx="5181600" cy="498993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093552"/>
            <a:ext cx="5181600" cy="498993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7CCDA-9449-5E45-AB41-756E31D23B49}" type="datetimeFigureOut">
              <a:rPr lang="en-US" smtClean="0"/>
              <a:t>5/3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4E55C-4A9F-5647-B041-27313B3B5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13056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18712"/>
            <a:ext cx="10515600" cy="15201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927889"/>
            <a:ext cx="5157787" cy="944829"/>
          </a:xfrm>
        </p:spPr>
        <p:txBody>
          <a:bodyPr anchor="b"/>
          <a:lstStyle>
            <a:lvl1pPr marL="0" indent="0">
              <a:buNone/>
              <a:defRPr sz="2752" b="1"/>
            </a:lvl1pPr>
            <a:lvl2pPr marL="524317" indent="0">
              <a:buNone/>
              <a:defRPr sz="2294" b="1"/>
            </a:lvl2pPr>
            <a:lvl3pPr marL="1048634" indent="0">
              <a:buNone/>
              <a:defRPr sz="2064" b="1"/>
            </a:lvl3pPr>
            <a:lvl4pPr marL="1572951" indent="0">
              <a:buNone/>
              <a:defRPr sz="1835" b="1"/>
            </a:lvl4pPr>
            <a:lvl5pPr marL="2097268" indent="0">
              <a:buNone/>
              <a:defRPr sz="1835" b="1"/>
            </a:lvl5pPr>
            <a:lvl6pPr marL="2621585" indent="0">
              <a:buNone/>
              <a:defRPr sz="1835" b="1"/>
            </a:lvl6pPr>
            <a:lvl7pPr marL="3145902" indent="0">
              <a:buNone/>
              <a:defRPr sz="1835" b="1"/>
            </a:lvl7pPr>
            <a:lvl8pPr marL="3670219" indent="0">
              <a:buNone/>
              <a:defRPr sz="1835" b="1"/>
            </a:lvl8pPr>
            <a:lvl9pPr marL="4194536" indent="0">
              <a:buNone/>
              <a:defRPr sz="1835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872718"/>
            <a:ext cx="5157787" cy="422533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1927889"/>
            <a:ext cx="5183188" cy="944829"/>
          </a:xfrm>
        </p:spPr>
        <p:txBody>
          <a:bodyPr anchor="b"/>
          <a:lstStyle>
            <a:lvl1pPr marL="0" indent="0">
              <a:buNone/>
              <a:defRPr sz="2752" b="1"/>
            </a:lvl1pPr>
            <a:lvl2pPr marL="524317" indent="0">
              <a:buNone/>
              <a:defRPr sz="2294" b="1"/>
            </a:lvl2pPr>
            <a:lvl3pPr marL="1048634" indent="0">
              <a:buNone/>
              <a:defRPr sz="2064" b="1"/>
            </a:lvl3pPr>
            <a:lvl4pPr marL="1572951" indent="0">
              <a:buNone/>
              <a:defRPr sz="1835" b="1"/>
            </a:lvl4pPr>
            <a:lvl5pPr marL="2097268" indent="0">
              <a:buNone/>
              <a:defRPr sz="1835" b="1"/>
            </a:lvl5pPr>
            <a:lvl6pPr marL="2621585" indent="0">
              <a:buNone/>
              <a:defRPr sz="1835" b="1"/>
            </a:lvl6pPr>
            <a:lvl7pPr marL="3145902" indent="0">
              <a:buNone/>
              <a:defRPr sz="1835" b="1"/>
            </a:lvl7pPr>
            <a:lvl8pPr marL="3670219" indent="0">
              <a:buNone/>
              <a:defRPr sz="1835" b="1"/>
            </a:lvl8pPr>
            <a:lvl9pPr marL="4194536" indent="0">
              <a:buNone/>
              <a:defRPr sz="1835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2872718"/>
            <a:ext cx="5183188" cy="422533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7CCDA-9449-5E45-AB41-756E31D23B49}" type="datetimeFigureOut">
              <a:rPr lang="en-US" smtClean="0"/>
              <a:t>5/31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4E55C-4A9F-5647-B041-27313B3B5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38847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7CCDA-9449-5E45-AB41-756E31D23B49}" type="datetimeFigureOut">
              <a:rPr lang="en-US" smtClean="0"/>
              <a:t>5/31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4E55C-4A9F-5647-B041-27313B3B5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79490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7CCDA-9449-5E45-AB41-756E31D23B49}" type="datetimeFigureOut">
              <a:rPr lang="en-US" smtClean="0"/>
              <a:t>5/31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4E55C-4A9F-5647-B041-27313B3B5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54518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24298"/>
            <a:ext cx="3932237" cy="1835044"/>
          </a:xfrm>
        </p:spPr>
        <p:txBody>
          <a:bodyPr anchor="b"/>
          <a:lstStyle>
            <a:lvl1pPr>
              <a:defRPr sz="367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132340"/>
            <a:ext cx="6172200" cy="5588875"/>
          </a:xfrm>
        </p:spPr>
        <p:txBody>
          <a:bodyPr/>
          <a:lstStyle>
            <a:lvl1pPr>
              <a:defRPr sz="3670"/>
            </a:lvl1pPr>
            <a:lvl2pPr>
              <a:defRPr sz="3211"/>
            </a:lvl2pPr>
            <a:lvl3pPr>
              <a:defRPr sz="2752"/>
            </a:lvl3pPr>
            <a:lvl4pPr>
              <a:defRPr sz="2294"/>
            </a:lvl4pPr>
            <a:lvl5pPr>
              <a:defRPr sz="2294"/>
            </a:lvl5pPr>
            <a:lvl6pPr>
              <a:defRPr sz="2294"/>
            </a:lvl6pPr>
            <a:lvl7pPr>
              <a:defRPr sz="2294"/>
            </a:lvl7pPr>
            <a:lvl8pPr>
              <a:defRPr sz="2294"/>
            </a:lvl8pPr>
            <a:lvl9pPr>
              <a:defRPr sz="2294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359342"/>
            <a:ext cx="3932237" cy="4370974"/>
          </a:xfrm>
        </p:spPr>
        <p:txBody>
          <a:bodyPr/>
          <a:lstStyle>
            <a:lvl1pPr marL="0" indent="0">
              <a:buNone/>
              <a:defRPr sz="1835"/>
            </a:lvl1pPr>
            <a:lvl2pPr marL="524317" indent="0">
              <a:buNone/>
              <a:defRPr sz="1606"/>
            </a:lvl2pPr>
            <a:lvl3pPr marL="1048634" indent="0">
              <a:buNone/>
              <a:defRPr sz="1376"/>
            </a:lvl3pPr>
            <a:lvl4pPr marL="1572951" indent="0">
              <a:buNone/>
              <a:defRPr sz="1147"/>
            </a:lvl4pPr>
            <a:lvl5pPr marL="2097268" indent="0">
              <a:buNone/>
              <a:defRPr sz="1147"/>
            </a:lvl5pPr>
            <a:lvl6pPr marL="2621585" indent="0">
              <a:buNone/>
              <a:defRPr sz="1147"/>
            </a:lvl6pPr>
            <a:lvl7pPr marL="3145902" indent="0">
              <a:buNone/>
              <a:defRPr sz="1147"/>
            </a:lvl7pPr>
            <a:lvl8pPr marL="3670219" indent="0">
              <a:buNone/>
              <a:defRPr sz="1147"/>
            </a:lvl8pPr>
            <a:lvl9pPr marL="4194536" indent="0">
              <a:buNone/>
              <a:defRPr sz="114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7CCDA-9449-5E45-AB41-756E31D23B49}" type="datetimeFigureOut">
              <a:rPr lang="en-US" smtClean="0"/>
              <a:t>5/3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4E55C-4A9F-5647-B041-27313B3B5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44700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24298"/>
            <a:ext cx="3932237" cy="1835044"/>
          </a:xfrm>
        </p:spPr>
        <p:txBody>
          <a:bodyPr anchor="b"/>
          <a:lstStyle>
            <a:lvl1pPr>
              <a:defRPr sz="367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132340"/>
            <a:ext cx="6172200" cy="5588875"/>
          </a:xfrm>
        </p:spPr>
        <p:txBody>
          <a:bodyPr anchor="t"/>
          <a:lstStyle>
            <a:lvl1pPr marL="0" indent="0">
              <a:buNone/>
              <a:defRPr sz="3670"/>
            </a:lvl1pPr>
            <a:lvl2pPr marL="524317" indent="0">
              <a:buNone/>
              <a:defRPr sz="3211"/>
            </a:lvl2pPr>
            <a:lvl3pPr marL="1048634" indent="0">
              <a:buNone/>
              <a:defRPr sz="2752"/>
            </a:lvl3pPr>
            <a:lvl4pPr marL="1572951" indent="0">
              <a:buNone/>
              <a:defRPr sz="2294"/>
            </a:lvl4pPr>
            <a:lvl5pPr marL="2097268" indent="0">
              <a:buNone/>
              <a:defRPr sz="2294"/>
            </a:lvl5pPr>
            <a:lvl6pPr marL="2621585" indent="0">
              <a:buNone/>
              <a:defRPr sz="2294"/>
            </a:lvl6pPr>
            <a:lvl7pPr marL="3145902" indent="0">
              <a:buNone/>
              <a:defRPr sz="2294"/>
            </a:lvl7pPr>
            <a:lvl8pPr marL="3670219" indent="0">
              <a:buNone/>
              <a:defRPr sz="2294"/>
            </a:lvl8pPr>
            <a:lvl9pPr marL="4194536" indent="0">
              <a:buNone/>
              <a:defRPr sz="2294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359342"/>
            <a:ext cx="3932237" cy="4370974"/>
          </a:xfrm>
        </p:spPr>
        <p:txBody>
          <a:bodyPr/>
          <a:lstStyle>
            <a:lvl1pPr marL="0" indent="0">
              <a:buNone/>
              <a:defRPr sz="1835"/>
            </a:lvl1pPr>
            <a:lvl2pPr marL="524317" indent="0">
              <a:buNone/>
              <a:defRPr sz="1606"/>
            </a:lvl2pPr>
            <a:lvl3pPr marL="1048634" indent="0">
              <a:buNone/>
              <a:defRPr sz="1376"/>
            </a:lvl3pPr>
            <a:lvl4pPr marL="1572951" indent="0">
              <a:buNone/>
              <a:defRPr sz="1147"/>
            </a:lvl4pPr>
            <a:lvl5pPr marL="2097268" indent="0">
              <a:buNone/>
              <a:defRPr sz="1147"/>
            </a:lvl5pPr>
            <a:lvl6pPr marL="2621585" indent="0">
              <a:buNone/>
              <a:defRPr sz="1147"/>
            </a:lvl6pPr>
            <a:lvl7pPr marL="3145902" indent="0">
              <a:buNone/>
              <a:defRPr sz="1147"/>
            </a:lvl7pPr>
            <a:lvl8pPr marL="3670219" indent="0">
              <a:buNone/>
              <a:defRPr sz="1147"/>
            </a:lvl8pPr>
            <a:lvl9pPr marL="4194536" indent="0">
              <a:buNone/>
              <a:defRPr sz="114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7CCDA-9449-5E45-AB41-756E31D23B49}" type="datetimeFigureOut">
              <a:rPr lang="en-US" smtClean="0"/>
              <a:t>5/3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4E55C-4A9F-5647-B041-27313B3B5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75287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18712"/>
            <a:ext cx="10515600" cy="15201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093552"/>
            <a:ext cx="10515600" cy="498993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7289205"/>
            <a:ext cx="2743200" cy="41871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76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797CCDA-9449-5E45-AB41-756E31D23B49}" type="datetimeFigureOut">
              <a:rPr lang="en-US" smtClean="0"/>
              <a:t>5/3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7289205"/>
            <a:ext cx="4114800" cy="41871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76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7289205"/>
            <a:ext cx="2743200" cy="41871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76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2C4E55C-4A9F-5647-B041-27313B3B5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22204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048634" rtl="0" eaLnBrk="1" latinLnBrk="0" hangingPunct="1">
        <a:lnSpc>
          <a:spcPct val="90000"/>
        </a:lnSpc>
        <a:spcBef>
          <a:spcPct val="0"/>
        </a:spcBef>
        <a:buNone/>
        <a:defRPr sz="504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2158" indent="-262158" algn="l" defTabSz="1048634" rtl="0" eaLnBrk="1" latinLnBrk="0" hangingPunct="1">
        <a:lnSpc>
          <a:spcPct val="90000"/>
        </a:lnSpc>
        <a:spcBef>
          <a:spcPts val="1147"/>
        </a:spcBef>
        <a:buFont typeface="Arial" panose="020B0604020202020204" pitchFamily="34" charset="0"/>
        <a:buChar char="•"/>
        <a:defRPr sz="3211" kern="1200">
          <a:solidFill>
            <a:schemeClr val="tx1"/>
          </a:solidFill>
          <a:latin typeface="+mn-lt"/>
          <a:ea typeface="+mn-ea"/>
          <a:cs typeface="+mn-cs"/>
        </a:defRPr>
      </a:lvl1pPr>
      <a:lvl2pPr marL="786475" indent="-262158" algn="l" defTabSz="1048634" rtl="0" eaLnBrk="1" latinLnBrk="0" hangingPunct="1">
        <a:lnSpc>
          <a:spcPct val="90000"/>
        </a:lnSpc>
        <a:spcBef>
          <a:spcPts val="573"/>
        </a:spcBef>
        <a:buFont typeface="Arial" panose="020B0604020202020204" pitchFamily="34" charset="0"/>
        <a:buChar char="•"/>
        <a:defRPr sz="2752" kern="1200">
          <a:solidFill>
            <a:schemeClr val="tx1"/>
          </a:solidFill>
          <a:latin typeface="+mn-lt"/>
          <a:ea typeface="+mn-ea"/>
          <a:cs typeface="+mn-cs"/>
        </a:defRPr>
      </a:lvl2pPr>
      <a:lvl3pPr marL="1310792" indent="-262158" algn="l" defTabSz="1048634" rtl="0" eaLnBrk="1" latinLnBrk="0" hangingPunct="1">
        <a:lnSpc>
          <a:spcPct val="90000"/>
        </a:lnSpc>
        <a:spcBef>
          <a:spcPts val="573"/>
        </a:spcBef>
        <a:buFont typeface="Arial" panose="020B0604020202020204" pitchFamily="34" charset="0"/>
        <a:buChar char="•"/>
        <a:defRPr sz="2294" kern="1200">
          <a:solidFill>
            <a:schemeClr val="tx1"/>
          </a:solidFill>
          <a:latin typeface="+mn-lt"/>
          <a:ea typeface="+mn-ea"/>
          <a:cs typeface="+mn-cs"/>
        </a:defRPr>
      </a:lvl3pPr>
      <a:lvl4pPr marL="1835109" indent="-262158" algn="l" defTabSz="1048634" rtl="0" eaLnBrk="1" latinLnBrk="0" hangingPunct="1">
        <a:lnSpc>
          <a:spcPct val="90000"/>
        </a:lnSpc>
        <a:spcBef>
          <a:spcPts val="573"/>
        </a:spcBef>
        <a:buFont typeface="Arial" panose="020B0604020202020204" pitchFamily="34" charset="0"/>
        <a:buChar char="•"/>
        <a:defRPr sz="2064" kern="1200">
          <a:solidFill>
            <a:schemeClr val="tx1"/>
          </a:solidFill>
          <a:latin typeface="+mn-lt"/>
          <a:ea typeface="+mn-ea"/>
          <a:cs typeface="+mn-cs"/>
        </a:defRPr>
      </a:lvl4pPr>
      <a:lvl5pPr marL="2359426" indent="-262158" algn="l" defTabSz="1048634" rtl="0" eaLnBrk="1" latinLnBrk="0" hangingPunct="1">
        <a:lnSpc>
          <a:spcPct val="90000"/>
        </a:lnSpc>
        <a:spcBef>
          <a:spcPts val="573"/>
        </a:spcBef>
        <a:buFont typeface="Arial" panose="020B0604020202020204" pitchFamily="34" charset="0"/>
        <a:buChar char="•"/>
        <a:defRPr sz="2064" kern="1200">
          <a:solidFill>
            <a:schemeClr val="tx1"/>
          </a:solidFill>
          <a:latin typeface="+mn-lt"/>
          <a:ea typeface="+mn-ea"/>
          <a:cs typeface="+mn-cs"/>
        </a:defRPr>
      </a:lvl5pPr>
      <a:lvl6pPr marL="2883743" indent="-262158" algn="l" defTabSz="1048634" rtl="0" eaLnBrk="1" latinLnBrk="0" hangingPunct="1">
        <a:lnSpc>
          <a:spcPct val="90000"/>
        </a:lnSpc>
        <a:spcBef>
          <a:spcPts val="573"/>
        </a:spcBef>
        <a:buFont typeface="Arial" panose="020B0604020202020204" pitchFamily="34" charset="0"/>
        <a:buChar char="•"/>
        <a:defRPr sz="2064" kern="1200">
          <a:solidFill>
            <a:schemeClr val="tx1"/>
          </a:solidFill>
          <a:latin typeface="+mn-lt"/>
          <a:ea typeface="+mn-ea"/>
          <a:cs typeface="+mn-cs"/>
        </a:defRPr>
      </a:lvl6pPr>
      <a:lvl7pPr marL="3408060" indent="-262158" algn="l" defTabSz="1048634" rtl="0" eaLnBrk="1" latinLnBrk="0" hangingPunct="1">
        <a:lnSpc>
          <a:spcPct val="90000"/>
        </a:lnSpc>
        <a:spcBef>
          <a:spcPts val="573"/>
        </a:spcBef>
        <a:buFont typeface="Arial" panose="020B0604020202020204" pitchFamily="34" charset="0"/>
        <a:buChar char="•"/>
        <a:defRPr sz="2064" kern="1200">
          <a:solidFill>
            <a:schemeClr val="tx1"/>
          </a:solidFill>
          <a:latin typeface="+mn-lt"/>
          <a:ea typeface="+mn-ea"/>
          <a:cs typeface="+mn-cs"/>
        </a:defRPr>
      </a:lvl7pPr>
      <a:lvl8pPr marL="3932377" indent="-262158" algn="l" defTabSz="1048634" rtl="0" eaLnBrk="1" latinLnBrk="0" hangingPunct="1">
        <a:lnSpc>
          <a:spcPct val="90000"/>
        </a:lnSpc>
        <a:spcBef>
          <a:spcPts val="573"/>
        </a:spcBef>
        <a:buFont typeface="Arial" panose="020B0604020202020204" pitchFamily="34" charset="0"/>
        <a:buChar char="•"/>
        <a:defRPr sz="2064" kern="1200">
          <a:solidFill>
            <a:schemeClr val="tx1"/>
          </a:solidFill>
          <a:latin typeface="+mn-lt"/>
          <a:ea typeface="+mn-ea"/>
          <a:cs typeface="+mn-cs"/>
        </a:defRPr>
      </a:lvl8pPr>
      <a:lvl9pPr marL="4456694" indent="-262158" algn="l" defTabSz="1048634" rtl="0" eaLnBrk="1" latinLnBrk="0" hangingPunct="1">
        <a:lnSpc>
          <a:spcPct val="90000"/>
        </a:lnSpc>
        <a:spcBef>
          <a:spcPts val="573"/>
        </a:spcBef>
        <a:buFont typeface="Arial" panose="020B0604020202020204" pitchFamily="34" charset="0"/>
        <a:buChar char="•"/>
        <a:defRPr sz="206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48634" rtl="0" eaLnBrk="1" latinLnBrk="0" hangingPunct="1">
        <a:defRPr sz="2064" kern="1200">
          <a:solidFill>
            <a:schemeClr val="tx1"/>
          </a:solidFill>
          <a:latin typeface="+mn-lt"/>
          <a:ea typeface="+mn-ea"/>
          <a:cs typeface="+mn-cs"/>
        </a:defRPr>
      </a:lvl1pPr>
      <a:lvl2pPr marL="524317" algn="l" defTabSz="1048634" rtl="0" eaLnBrk="1" latinLnBrk="0" hangingPunct="1">
        <a:defRPr sz="2064" kern="1200">
          <a:solidFill>
            <a:schemeClr val="tx1"/>
          </a:solidFill>
          <a:latin typeface="+mn-lt"/>
          <a:ea typeface="+mn-ea"/>
          <a:cs typeface="+mn-cs"/>
        </a:defRPr>
      </a:lvl2pPr>
      <a:lvl3pPr marL="1048634" algn="l" defTabSz="1048634" rtl="0" eaLnBrk="1" latinLnBrk="0" hangingPunct="1">
        <a:defRPr sz="2064" kern="1200">
          <a:solidFill>
            <a:schemeClr val="tx1"/>
          </a:solidFill>
          <a:latin typeface="+mn-lt"/>
          <a:ea typeface="+mn-ea"/>
          <a:cs typeface="+mn-cs"/>
        </a:defRPr>
      </a:lvl3pPr>
      <a:lvl4pPr marL="1572951" algn="l" defTabSz="1048634" rtl="0" eaLnBrk="1" latinLnBrk="0" hangingPunct="1">
        <a:defRPr sz="2064" kern="1200">
          <a:solidFill>
            <a:schemeClr val="tx1"/>
          </a:solidFill>
          <a:latin typeface="+mn-lt"/>
          <a:ea typeface="+mn-ea"/>
          <a:cs typeface="+mn-cs"/>
        </a:defRPr>
      </a:lvl4pPr>
      <a:lvl5pPr marL="2097268" algn="l" defTabSz="1048634" rtl="0" eaLnBrk="1" latinLnBrk="0" hangingPunct="1">
        <a:defRPr sz="2064" kern="1200">
          <a:solidFill>
            <a:schemeClr val="tx1"/>
          </a:solidFill>
          <a:latin typeface="+mn-lt"/>
          <a:ea typeface="+mn-ea"/>
          <a:cs typeface="+mn-cs"/>
        </a:defRPr>
      </a:lvl5pPr>
      <a:lvl6pPr marL="2621585" algn="l" defTabSz="1048634" rtl="0" eaLnBrk="1" latinLnBrk="0" hangingPunct="1">
        <a:defRPr sz="2064" kern="1200">
          <a:solidFill>
            <a:schemeClr val="tx1"/>
          </a:solidFill>
          <a:latin typeface="+mn-lt"/>
          <a:ea typeface="+mn-ea"/>
          <a:cs typeface="+mn-cs"/>
        </a:defRPr>
      </a:lvl6pPr>
      <a:lvl7pPr marL="3145902" algn="l" defTabSz="1048634" rtl="0" eaLnBrk="1" latinLnBrk="0" hangingPunct="1">
        <a:defRPr sz="2064" kern="1200">
          <a:solidFill>
            <a:schemeClr val="tx1"/>
          </a:solidFill>
          <a:latin typeface="+mn-lt"/>
          <a:ea typeface="+mn-ea"/>
          <a:cs typeface="+mn-cs"/>
        </a:defRPr>
      </a:lvl7pPr>
      <a:lvl8pPr marL="3670219" algn="l" defTabSz="1048634" rtl="0" eaLnBrk="1" latinLnBrk="0" hangingPunct="1">
        <a:defRPr sz="2064" kern="1200">
          <a:solidFill>
            <a:schemeClr val="tx1"/>
          </a:solidFill>
          <a:latin typeface="+mn-lt"/>
          <a:ea typeface="+mn-ea"/>
          <a:cs typeface="+mn-cs"/>
        </a:defRPr>
      </a:lvl8pPr>
      <a:lvl9pPr marL="4194536" algn="l" defTabSz="1048634" rtl="0" eaLnBrk="1" latinLnBrk="0" hangingPunct="1">
        <a:defRPr sz="206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18" Type="http://schemas.openxmlformats.org/officeDocument/2006/relationships/image" Target="../media/image17.emf"/><Relationship Id="rId3" Type="http://schemas.openxmlformats.org/officeDocument/2006/relationships/image" Target="../media/image2.emf"/><Relationship Id="rId21" Type="http://schemas.openxmlformats.org/officeDocument/2006/relationships/image" Target="../media/image20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17" Type="http://schemas.openxmlformats.org/officeDocument/2006/relationships/image" Target="../media/image16.emf"/><Relationship Id="rId2" Type="http://schemas.openxmlformats.org/officeDocument/2006/relationships/image" Target="../media/image1.emf"/><Relationship Id="rId16" Type="http://schemas.openxmlformats.org/officeDocument/2006/relationships/image" Target="../media/image15.emf"/><Relationship Id="rId20" Type="http://schemas.openxmlformats.org/officeDocument/2006/relationships/image" Target="../media/image19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5" Type="http://schemas.openxmlformats.org/officeDocument/2006/relationships/image" Target="../media/image14.emf"/><Relationship Id="rId10" Type="http://schemas.openxmlformats.org/officeDocument/2006/relationships/image" Target="../media/image9.emf"/><Relationship Id="rId19" Type="http://schemas.openxmlformats.org/officeDocument/2006/relationships/image" Target="../media/image18.emf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4" Type="http://schemas.openxmlformats.org/officeDocument/2006/relationships/image" Target="../media/image13.emf"/><Relationship Id="rId22" Type="http://schemas.openxmlformats.org/officeDocument/2006/relationships/image" Target="../media/image21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emf"/><Relationship Id="rId13" Type="http://schemas.openxmlformats.org/officeDocument/2006/relationships/image" Target="../media/image33.emf"/><Relationship Id="rId18" Type="http://schemas.openxmlformats.org/officeDocument/2006/relationships/image" Target="../media/image38.emf"/><Relationship Id="rId3" Type="http://schemas.openxmlformats.org/officeDocument/2006/relationships/image" Target="../media/image23.emf"/><Relationship Id="rId7" Type="http://schemas.openxmlformats.org/officeDocument/2006/relationships/image" Target="../media/image27.emf"/><Relationship Id="rId12" Type="http://schemas.openxmlformats.org/officeDocument/2006/relationships/image" Target="../media/image32.emf"/><Relationship Id="rId17" Type="http://schemas.openxmlformats.org/officeDocument/2006/relationships/image" Target="../media/image37.emf"/><Relationship Id="rId2" Type="http://schemas.openxmlformats.org/officeDocument/2006/relationships/image" Target="../media/image22.emf"/><Relationship Id="rId16" Type="http://schemas.openxmlformats.org/officeDocument/2006/relationships/image" Target="../media/image36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6.emf"/><Relationship Id="rId11" Type="http://schemas.openxmlformats.org/officeDocument/2006/relationships/image" Target="../media/image31.emf"/><Relationship Id="rId5" Type="http://schemas.openxmlformats.org/officeDocument/2006/relationships/image" Target="../media/image25.emf"/><Relationship Id="rId15" Type="http://schemas.openxmlformats.org/officeDocument/2006/relationships/image" Target="../media/image35.emf"/><Relationship Id="rId10" Type="http://schemas.openxmlformats.org/officeDocument/2006/relationships/image" Target="../media/image30.emf"/><Relationship Id="rId4" Type="http://schemas.openxmlformats.org/officeDocument/2006/relationships/image" Target="../media/image24.emf"/><Relationship Id="rId9" Type="http://schemas.openxmlformats.org/officeDocument/2006/relationships/image" Target="../media/image29.emf"/><Relationship Id="rId14" Type="http://schemas.openxmlformats.org/officeDocument/2006/relationships/image" Target="../media/image34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emf"/><Relationship Id="rId2" Type="http://schemas.openxmlformats.org/officeDocument/2006/relationships/image" Target="../media/image39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2.emf"/><Relationship Id="rId4" Type="http://schemas.openxmlformats.org/officeDocument/2006/relationships/image" Target="../media/image41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tif"/><Relationship Id="rId2" Type="http://schemas.openxmlformats.org/officeDocument/2006/relationships/image" Target="../media/image43.t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Picture 53">
            <a:extLst>
              <a:ext uri="{FF2B5EF4-FFF2-40B4-BE49-F238E27FC236}">
                <a16:creationId xmlns:a16="http://schemas.microsoft.com/office/drawing/2014/main" id="{7DF7FF9A-A750-A134-754F-5CBE14D0EC0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95487" y="787724"/>
            <a:ext cx="957141" cy="1479949"/>
          </a:xfrm>
          <a:prstGeom prst="rect">
            <a:avLst/>
          </a:prstGeom>
        </p:spPr>
      </p:pic>
      <p:pic>
        <p:nvPicPr>
          <p:cNvPr id="56" name="Picture 55">
            <a:extLst>
              <a:ext uri="{FF2B5EF4-FFF2-40B4-BE49-F238E27FC236}">
                <a16:creationId xmlns:a16="http://schemas.microsoft.com/office/drawing/2014/main" id="{A2B9A6A1-9A72-3231-7B23-A55A7D2DD74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29721" y="2623089"/>
            <a:ext cx="1124243" cy="1484001"/>
          </a:xfrm>
          <a:prstGeom prst="rect">
            <a:avLst/>
          </a:prstGeom>
        </p:spPr>
      </p:pic>
      <p:pic>
        <p:nvPicPr>
          <p:cNvPr id="57" name="Picture 56">
            <a:extLst>
              <a:ext uri="{FF2B5EF4-FFF2-40B4-BE49-F238E27FC236}">
                <a16:creationId xmlns:a16="http://schemas.microsoft.com/office/drawing/2014/main" id="{FE28B5F0-F394-228F-068B-B9AF241A20A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07664" y="2621323"/>
            <a:ext cx="1000828" cy="1488627"/>
          </a:xfrm>
          <a:prstGeom prst="rect">
            <a:avLst/>
          </a:prstGeom>
        </p:spPr>
      </p:pic>
      <p:pic>
        <p:nvPicPr>
          <p:cNvPr id="58" name="Picture 57">
            <a:extLst>
              <a:ext uri="{FF2B5EF4-FFF2-40B4-BE49-F238E27FC236}">
                <a16:creationId xmlns:a16="http://schemas.microsoft.com/office/drawing/2014/main" id="{7CB00408-C7F2-25E2-1965-CAFE919853E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787857" y="2555068"/>
            <a:ext cx="1077797" cy="1543405"/>
          </a:xfrm>
          <a:prstGeom prst="rect">
            <a:avLst/>
          </a:prstGeom>
        </p:spPr>
      </p:pic>
      <p:pic>
        <p:nvPicPr>
          <p:cNvPr id="60" name="Picture 59">
            <a:extLst>
              <a:ext uri="{FF2B5EF4-FFF2-40B4-BE49-F238E27FC236}">
                <a16:creationId xmlns:a16="http://schemas.microsoft.com/office/drawing/2014/main" id="{1B300279-F144-FC30-C843-496AA815D9E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6099" y="757107"/>
            <a:ext cx="1198601" cy="1510564"/>
          </a:xfrm>
          <a:prstGeom prst="rect">
            <a:avLst/>
          </a:prstGeom>
        </p:spPr>
      </p:pic>
      <p:pic>
        <p:nvPicPr>
          <p:cNvPr id="61" name="Picture 60">
            <a:extLst>
              <a:ext uri="{FF2B5EF4-FFF2-40B4-BE49-F238E27FC236}">
                <a16:creationId xmlns:a16="http://schemas.microsoft.com/office/drawing/2014/main" id="{288B8713-2E66-89E7-45E7-848544C9FB4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440605" y="820224"/>
            <a:ext cx="1263585" cy="1479952"/>
          </a:xfrm>
          <a:prstGeom prst="rect">
            <a:avLst/>
          </a:prstGeom>
        </p:spPr>
      </p:pic>
      <p:pic>
        <p:nvPicPr>
          <p:cNvPr id="62" name="Picture 61">
            <a:extLst>
              <a:ext uri="{FF2B5EF4-FFF2-40B4-BE49-F238E27FC236}">
                <a16:creationId xmlns:a16="http://schemas.microsoft.com/office/drawing/2014/main" id="{B70C21D8-A903-70E2-CE2D-2D260E79843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20816" y="2644247"/>
            <a:ext cx="1293851" cy="1479952"/>
          </a:xfrm>
          <a:prstGeom prst="rect">
            <a:avLst/>
          </a:prstGeom>
        </p:spPr>
      </p:pic>
      <p:pic>
        <p:nvPicPr>
          <p:cNvPr id="63" name="Picture 62">
            <a:extLst>
              <a:ext uri="{FF2B5EF4-FFF2-40B4-BE49-F238E27FC236}">
                <a16:creationId xmlns:a16="http://schemas.microsoft.com/office/drawing/2014/main" id="{E577A6E1-CFEA-AD66-1ED0-7A1DF07E876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450911" y="2495264"/>
            <a:ext cx="1260090" cy="1622581"/>
          </a:xfrm>
          <a:prstGeom prst="rect">
            <a:avLst/>
          </a:prstGeom>
        </p:spPr>
      </p:pic>
      <p:pic>
        <p:nvPicPr>
          <p:cNvPr id="64" name="Picture 63">
            <a:extLst>
              <a:ext uri="{FF2B5EF4-FFF2-40B4-BE49-F238E27FC236}">
                <a16:creationId xmlns:a16="http://schemas.microsoft.com/office/drawing/2014/main" id="{7CEECBAF-AA72-9FE8-4143-81FDB84A3CEE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386185" y="2529031"/>
            <a:ext cx="1241765" cy="1590480"/>
          </a:xfrm>
          <a:prstGeom prst="rect">
            <a:avLst/>
          </a:prstGeom>
        </p:spPr>
      </p:pic>
      <p:pic>
        <p:nvPicPr>
          <p:cNvPr id="66" name="Picture 65">
            <a:extLst>
              <a:ext uri="{FF2B5EF4-FFF2-40B4-BE49-F238E27FC236}">
                <a16:creationId xmlns:a16="http://schemas.microsoft.com/office/drawing/2014/main" id="{77696367-1564-E1BA-B754-89D7BDF2E2A4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818671" y="799629"/>
            <a:ext cx="957141" cy="1479951"/>
          </a:xfrm>
          <a:prstGeom prst="rect">
            <a:avLst/>
          </a:prstGeom>
        </p:spPr>
      </p:pic>
      <p:pic>
        <p:nvPicPr>
          <p:cNvPr id="69" name="Picture 68">
            <a:extLst>
              <a:ext uri="{FF2B5EF4-FFF2-40B4-BE49-F238E27FC236}">
                <a16:creationId xmlns:a16="http://schemas.microsoft.com/office/drawing/2014/main" id="{60075EE4-A018-E14E-A9DF-7AF43B596593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814940" y="731904"/>
            <a:ext cx="998180" cy="1543405"/>
          </a:xfrm>
          <a:prstGeom prst="rect">
            <a:avLst/>
          </a:prstGeom>
        </p:spPr>
      </p:pic>
      <p:pic>
        <p:nvPicPr>
          <p:cNvPr id="70" name="Picture 69">
            <a:extLst>
              <a:ext uri="{FF2B5EF4-FFF2-40B4-BE49-F238E27FC236}">
                <a16:creationId xmlns:a16="http://schemas.microsoft.com/office/drawing/2014/main" id="{0D5A2CA2-1653-0319-8FBD-7676D7463309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811970" y="2556981"/>
            <a:ext cx="998180" cy="1543405"/>
          </a:xfrm>
          <a:prstGeom prst="rect">
            <a:avLst/>
          </a:prstGeom>
        </p:spPr>
      </p:pic>
      <p:pic>
        <p:nvPicPr>
          <p:cNvPr id="71" name="Picture 70">
            <a:extLst>
              <a:ext uri="{FF2B5EF4-FFF2-40B4-BE49-F238E27FC236}">
                <a16:creationId xmlns:a16="http://schemas.microsoft.com/office/drawing/2014/main" id="{9DA9356C-F4A6-2556-7D15-2EEA3F6AD8D0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9708810" y="2488724"/>
            <a:ext cx="1041087" cy="1609748"/>
          </a:xfrm>
          <a:prstGeom prst="rect">
            <a:avLst/>
          </a:prstGeom>
        </p:spPr>
      </p:pic>
      <p:pic>
        <p:nvPicPr>
          <p:cNvPr id="73" name="Picture 72">
            <a:extLst>
              <a:ext uri="{FF2B5EF4-FFF2-40B4-BE49-F238E27FC236}">
                <a16:creationId xmlns:a16="http://schemas.microsoft.com/office/drawing/2014/main" id="{347B2510-1E8B-57F9-C92A-3EE5DBDAC4EF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6848585" y="768683"/>
            <a:ext cx="1117282" cy="1510565"/>
          </a:xfrm>
          <a:prstGeom prst="rect">
            <a:avLst/>
          </a:prstGeom>
        </p:spPr>
      </p:pic>
      <p:pic>
        <p:nvPicPr>
          <p:cNvPr id="75" name="Picture 74">
            <a:extLst>
              <a:ext uri="{FF2B5EF4-FFF2-40B4-BE49-F238E27FC236}">
                <a16:creationId xmlns:a16="http://schemas.microsoft.com/office/drawing/2014/main" id="{9E40D6DD-0394-8361-A2B9-CF1E48407B96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756249" y="2462721"/>
            <a:ext cx="1124242" cy="1636896"/>
          </a:xfrm>
          <a:prstGeom prst="rect">
            <a:avLst/>
          </a:prstGeom>
        </p:spPr>
      </p:pic>
      <p:sp>
        <p:nvSpPr>
          <p:cNvPr id="78" name="TextBox 77">
            <a:extLst>
              <a:ext uri="{FF2B5EF4-FFF2-40B4-BE49-F238E27FC236}">
                <a16:creationId xmlns:a16="http://schemas.microsoft.com/office/drawing/2014/main" id="{F13FF1CF-84B7-0C25-BA91-6DFD10B5C592}"/>
              </a:ext>
            </a:extLst>
          </p:cNvPr>
          <p:cNvSpPr txBox="1"/>
          <p:nvPr/>
        </p:nvSpPr>
        <p:spPr>
          <a:xfrm>
            <a:off x="878749" y="447470"/>
            <a:ext cx="676788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dirty="0">
                <a:latin typeface="Arial" panose="020B0604020202020204" pitchFamily="34" charset="0"/>
                <a:cs typeface="Arial" panose="020B0604020202020204" pitchFamily="34" charset="0"/>
              </a:rPr>
              <a:t>1 month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68745FF5-343A-ECCA-0A74-1606CA858A37}"/>
              </a:ext>
            </a:extLst>
          </p:cNvPr>
          <p:cNvSpPr txBox="1"/>
          <p:nvPr/>
        </p:nvSpPr>
        <p:spPr>
          <a:xfrm>
            <a:off x="3132063" y="451371"/>
            <a:ext cx="745717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dirty="0">
                <a:latin typeface="Arial" panose="020B0604020202020204" pitchFamily="34" charset="0"/>
                <a:cs typeface="Arial" panose="020B0604020202020204" pitchFamily="34" charset="0"/>
              </a:rPr>
              <a:t>2 months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87D63E16-07D1-8A86-E072-3DCE40C354C2}"/>
              </a:ext>
            </a:extLst>
          </p:cNvPr>
          <p:cNvSpPr txBox="1"/>
          <p:nvPr/>
        </p:nvSpPr>
        <p:spPr>
          <a:xfrm>
            <a:off x="1918091" y="448473"/>
            <a:ext cx="790601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dirty="0">
                <a:latin typeface="Arial" panose="020B0604020202020204" pitchFamily="34" charset="0"/>
                <a:cs typeface="Arial" panose="020B0604020202020204" pitchFamily="34" charset="0"/>
              </a:rPr>
              <a:t>1.5 month</a:t>
            </a:r>
          </a:p>
        </p:txBody>
      </p:sp>
      <p:pic>
        <p:nvPicPr>
          <p:cNvPr id="85" name="Picture 84">
            <a:extLst>
              <a:ext uri="{FF2B5EF4-FFF2-40B4-BE49-F238E27FC236}">
                <a16:creationId xmlns:a16="http://schemas.microsoft.com/office/drawing/2014/main" id="{BB59BF3B-F5D1-0F70-E342-199F2B476151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818672" y="4408045"/>
            <a:ext cx="1087081" cy="1600182"/>
          </a:xfrm>
          <a:prstGeom prst="rect">
            <a:avLst/>
          </a:prstGeom>
        </p:spPr>
      </p:pic>
      <p:pic>
        <p:nvPicPr>
          <p:cNvPr id="86" name="Picture 85">
            <a:extLst>
              <a:ext uri="{FF2B5EF4-FFF2-40B4-BE49-F238E27FC236}">
                <a16:creationId xmlns:a16="http://schemas.microsoft.com/office/drawing/2014/main" id="{8ABC492F-D779-A9DB-BC3E-30CCF4FDA1D6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4439533" y="4430971"/>
            <a:ext cx="1260090" cy="1577254"/>
          </a:xfrm>
          <a:prstGeom prst="rect">
            <a:avLst/>
          </a:prstGeom>
        </p:spPr>
      </p:pic>
      <p:pic>
        <p:nvPicPr>
          <p:cNvPr id="87" name="Picture 86">
            <a:extLst>
              <a:ext uri="{FF2B5EF4-FFF2-40B4-BE49-F238E27FC236}">
                <a16:creationId xmlns:a16="http://schemas.microsoft.com/office/drawing/2014/main" id="{7307181F-BF35-9F29-386D-3C71615EB9A2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6907782" y="4471150"/>
            <a:ext cx="1009150" cy="1543405"/>
          </a:xfrm>
          <a:prstGeom prst="rect">
            <a:avLst/>
          </a:prstGeom>
        </p:spPr>
      </p:pic>
      <p:pic>
        <p:nvPicPr>
          <p:cNvPr id="88" name="Picture 87">
            <a:extLst>
              <a:ext uri="{FF2B5EF4-FFF2-40B4-BE49-F238E27FC236}">
                <a16:creationId xmlns:a16="http://schemas.microsoft.com/office/drawing/2014/main" id="{7A98BB0B-9427-7541-65C1-8042E355857B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5820224" y="4490858"/>
            <a:ext cx="998180" cy="1526629"/>
          </a:xfrm>
          <a:prstGeom prst="rect">
            <a:avLst/>
          </a:prstGeom>
        </p:spPr>
      </p:pic>
      <p:pic>
        <p:nvPicPr>
          <p:cNvPr id="89" name="Picture 88">
            <a:extLst>
              <a:ext uri="{FF2B5EF4-FFF2-40B4-BE49-F238E27FC236}">
                <a16:creationId xmlns:a16="http://schemas.microsoft.com/office/drawing/2014/main" id="{3B60DE62-A141-3E88-126E-42220E1C38EC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2931052" y="4455561"/>
            <a:ext cx="1124242" cy="1561924"/>
          </a:xfrm>
          <a:prstGeom prst="rect">
            <a:avLst/>
          </a:prstGeom>
        </p:spPr>
      </p:pic>
      <p:pic>
        <p:nvPicPr>
          <p:cNvPr id="90" name="Picture 89">
            <a:extLst>
              <a:ext uri="{FF2B5EF4-FFF2-40B4-BE49-F238E27FC236}">
                <a16:creationId xmlns:a16="http://schemas.microsoft.com/office/drawing/2014/main" id="{65EBC32F-35A4-DD4B-E909-9FACA955FFC0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406532" y="4381998"/>
            <a:ext cx="1363985" cy="1629696"/>
          </a:xfrm>
          <a:prstGeom prst="rect">
            <a:avLst/>
          </a:prstGeom>
        </p:spPr>
      </p:pic>
      <p:sp>
        <p:nvSpPr>
          <p:cNvPr id="91" name="TextBox 90">
            <a:extLst>
              <a:ext uri="{FF2B5EF4-FFF2-40B4-BE49-F238E27FC236}">
                <a16:creationId xmlns:a16="http://schemas.microsoft.com/office/drawing/2014/main" id="{467879CB-1327-CE46-829E-90CEECEEF974}"/>
              </a:ext>
            </a:extLst>
          </p:cNvPr>
          <p:cNvSpPr txBox="1"/>
          <p:nvPr/>
        </p:nvSpPr>
        <p:spPr>
          <a:xfrm>
            <a:off x="4868981" y="447501"/>
            <a:ext cx="676788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dirty="0">
                <a:latin typeface="Arial" panose="020B0604020202020204" pitchFamily="34" charset="0"/>
                <a:cs typeface="Arial" panose="020B0604020202020204" pitchFamily="34" charset="0"/>
              </a:rPr>
              <a:t>1 month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719259C9-8880-0C0B-DF89-CF70C3A5E63F}"/>
              </a:ext>
            </a:extLst>
          </p:cNvPr>
          <p:cNvSpPr txBox="1"/>
          <p:nvPr/>
        </p:nvSpPr>
        <p:spPr>
          <a:xfrm>
            <a:off x="7112732" y="451402"/>
            <a:ext cx="745717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dirty="0">
                <a:latin typeface="Arial" panose="020B0604020202020204" pitchFamily="34" charset="0"/>
                <a:cs typeface="Arial" panose="020B0604020202020204" pitchFamily="34" charset="0"/>
              </a:rPr>
              <a:t>2 months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60CFDEE8-5DC8-B814-0C3C-1507F2E5F44D}"/>
              </a:ext>
            </a:extLst>
          </p:cNvPr>
          <p:cNvSpPr txBox="1"/>
          <p:nvPr/>
        </p:nvSpPr>
        <p:spPr>
          <a:xfrm>
            <a:off x="5908323" y="448505"/>
            <a:ext cx="790601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dirty="0">
                <a:latin typeface="Arial" panose="020B0604020202020204" pitchFamily="34" charset="0"/>
                <a:cs typeface="Arial" panose="020B0604020202020204" pitchFamily="34" charset="0"/>
              </a:rPr>
              <a:t>1.5 month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D92690FF-FE92-FB15-2780-CD39E7C57A78}"/>
              </a:ext>
            </a:extLst>
          </p:cNvPr>
          <p:cNvSpPr txBox="1"/>
          <p:nvPr/>
        </p:nvSpPr>
        <p:spPr>
          <a:xfrm>
            <a:off x="8720286" y="2248448"/>
            <a:ext cx="676788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dirty="0">
                <a:latin typeface="Arial" panose="020B0604020202020204" pitchFamily="34" charset="0"/>
                <a:cs typeface="Arial" panose="020B0604020202020204" pitchFamily="34" charset="0"/>
              </a:rPr>
              <a:t>1 month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723C918C-26CB-1F8D-1B77-0CEFC7F02660}"/>
              </a:ext>
            </a:extLst>
          </p:cNvPr>
          <p:cNvSpPr txBox="1"/>
          <p:nvPr/>
        </p:nvSpPr>
        <p:spPr>
          <a:xfrm>
            <a:off x="10992725" y="2252348"/>
            <a:ext cx="745717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dirty="0">
                <a:latin typeface="Arial" panose="020B0604020202020204" pitchFamily="34" charset="0"/>
                <a:cs typeface="Arial" panose="020B0604020202020204" pitchFamily="34" charset="0"/>
              </a:rPr>
              <a:t>2 months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EBEB21D5-FE92-F8A3-17F3-4DE7ADD4DB41}"/>
              </a:ext>
            </a:extLst>
          </p:cNvPr>
          <p:cNvSpPr txBox="1"/>
          <p:nvPr/>
        </p:nvSpPr>
        <p:spPr>
          <a:xfrm>
            <a:off x="9759628" y="2249452"/>
            <a:ext cx="790601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dirty="0">
                <a:latin typeface="Arial" panose="020B0604020202020204" pitchFamily="34" charset="0"/>
                <a:cs typeface="Arial" panose="020B0604020202020204" pitchFamily="34" charset="0"/>
              </a:rPr>
              <a:t>1.5 month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18AFC7DB-3D67-E469-AAFC-4AA2F75B53C1}"/>
              </a:ext>
            </a:extLst>
          </p:cNvPr>
          <p:cNvSpPr txBox="1"/>
          <p:nvPr/>
        </p:nvSpPr>
        <p:spPr>
          <a:xfrm>
            <a:off x="0" y="6339748"/>
            <a:ext cx="12192000" cy="1169551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1.  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lative mRNA expression of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ell cycle regulation genes CCNC, CCND1, CCND2, CCNE1, CCNE2, CDK1, CDK2 and in iPSC derived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C9orf72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 motor neurons compared to control motor neurons.</a:t>
            </a:r>
          </a:p>
          <a:p>
            <a:pPr algn="just"/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ata presented is from 3 control iPSC and 3 C9orf72 iPSC lines from 3 independent differentiation experiments. Two-tailed t-test with Welch’s correction was applied. ns, not significant, *p&lt;0.05, **p&lt;0.01. 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2552A5CE-8F9D-52AE-C91E-414D043A0E69}"/>
              </a:ext>
            </a:extLst>
          </p:cNvPr>
          <p:cNvGrpSpPr/>
          <p:nvPr/>
        </p:nvGrpSpPr>
        <p:grpSpPr>
          <a:xfrm>
            <a:off x="9006479" y="957686"/>
            <a:ext cx="972929" cy="558279"/>
            <a:chOff x="7836041" y="676294"/>
            <a:chExt cx="912121" cy="523385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C274F480-1FEA-0921-941B-17B34564118B}"/>
                </a:ext>
              </a:extLst>
            </p:cNvPr>
            <p:cNvSpPr txBox="1"/>
            <p:nvPr/>
          </p:nvSpPr>
          <p:spPr>
            <a:xfrm>
              <a:off x="7836592" y="739541"/>
              <a:ext cx="171450" cy="171449"/>
            </a:xfrm>
            <a:prstGeom prst="rect">
              <a:avLst/>
            </a:prstGeom>
            <a:solidFill>
              <a:srgbClr val="0218BE"/>
            </a:solidFill>
          </p:spPr>
          <p:txBody>
            <a:bodyPr wrap="square" rtlCol="0">
              <a:spAutoFit/>
            </a:bodyPr>
            <a:lstStyle/>
            <a:p>
              <a:endParaRPr lang="en-US" sz="1920" dirty="0"/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E989696A-0DC5-FA83-9AD4-2FF227D68FC7}"/>
                </a:ext>
              </a:extLst>
            </p:cNvPr>
            <p:cNvSpPr txBox="1"/>
            <p:nvPr/>
          </p:nvSpPr>
          <p:spPr>
            <a:xfrm>
              <a:off x="7948733" y="676294"/>
              <a:ext cx="758260" cy="3019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93" dirty="0"/>
                <a:t>Control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54B6295F-F82C-A21C-F1E9-276C05FF9CEF}"/>
                </a:ext>
              </a:extLst>
            </p:cNvPr>
            <p:cNvSpPr txBox="1"/>
            <p:nvPr/>
          </p:nvSpPr>
          <p:spPr>
            <a:xfrm>
              <a:off x="7951188" y="897733"/>
              <a:ext cx="796974" cy="3019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93" i="1" dirty="0"/>
                <a:t>C9orf72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D4917388-C801-4705-FDDB-A2D89BE0329E}"/>
                </a:ext>
              </a:extLst>
            </p:cNvPr>
            <p:cNvSpPr txBox="1">
              <a:spLocks/>
            </p:cNvSpPr>
            <p:nvPr/>
          </p:nvSpPr>
          <p:spPr>
            <a:xfrm>
              <a:off x="7836041" y="966461"/>
              <a:ext cx="171450" cy="171450"/>
            </a:xfrm>
            <a:prstGeom prst="rect">
              <a:avLst/>
            </a:prstGeom>
            <a:solidFill>
              <a:srgbClr val="FF0000"/>
            </a:solidFill>
          </p:spPr>
          <p:txBody>
            <a:bodyPr wrap="square" rtlCol="0">
              <a:spAutoFit/>
            </a:bodyPr>
            <a:lstStyle/>
            <a:p>
              <a:endParaRPr lang="en-US" sz="1920" dirty="0"/>
            </a:p>
          </p:txBody>
        </p:sp>
      </p:grpSp>
    </p:spTree>
    <p:extLst>
      <p:ext uri="{BB962C8B-B14F-4D97-AF65-F5344CB8AC3E}">
        <p14:creationId xmlns:p14="http://schemas.microsoft.com/office/powerpoint/2010/main" val="34587026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>
            <a:extLst>
              <a:ext uri="{FF2B5EF4-FFF2-40B4-BE49-F238E27FC236}">
                <a16:creationId xmlns:a16="http://schemas.microsoft.com/office/drawing/2014/main" id="{04906D0B-C8BE-C26F-3039-FBB8714EF0F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413" y="301073"/>
            <a:ext cx="1306283" cy="1985852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D9F9956C-69C5-1E9B-255B-0EFFD1094197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12341"/>
          <a:stretch>
            <a:fillRect/>
          </a:stretch>
        </p:blipFill>
        <p:spPr>
          <a:xfrm>
            <a:off x="1319547" y="293433"/>
            <a:ext cx="1171543" cy="1985852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E8CE13AD-2083-8CAD-98F5-19DA10CC8E07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12342"/>
          <a:stretch>
            <a:fillRect/>
          </a:stretch>
        </p:blipFill>
        <p:spPr>
          <a:xfrm>
            <a:off x="2562130" y="316349"/>
            <a:ext cx="1231489" cy="1984282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4DC52490-2A00-9EC7-46AF-352B138EBCB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070755" y="289093"/>
            <a:ext cx="1234650" cy="1985853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C3C62FB7-C856-226C-6745-B6C1A9577B7F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10378" r="254"/>
          <a:stretch>
            <a:fillRect/>
          </a:stretch>
        </p:blipFill>
        <p:spPr>
          <a:xfrm>
            <a:off x="5421381" y="421278"/>
            <a:ext cx="1120147" cy="1868869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9E2CCFC7-DEC8-57BD-9056-AA027EE1ED92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10429"/>
          <a:stretch>
            <a:fillRect/>
          </a:stretch>
        </p:blipFill>
        <p:spPr>
          <a:xfrm>
            <a:off x="6657501" y="294555"/>
            <a:ext cx="1104540" cy="1993699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E0C8B563-F01E-32D4-C470-332A195B04B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319225" y="323515"/>
            <a:ext cx="1305660" cy="1985854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A355971E-3D3E-E8AD-AEC3-D4CE7AE04433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 l="10533" r="-1"/>
          <a:stretch>
            <a:fillRect/>
          </a:stretch>
        </p:blipFill>
        <p:spPr>
          <a:xfrm>
            <a:off x="9668907" y="336092"/>
            <a:ext cx="1154610" cy="1970576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0619B4F6-C2EA-5E20-4846-5B15C16154B0}"/>
              </a:ext>
            </a:extLst>
          </p:cNvPr>
          <p:cNvPicPr>
            <a:picLocks noChangeAspect="1"/>
          </p:cNvPicPr>
          <p:nvPr/>
        </p:nvPicPr>
        <p:blipFill>
          <a:blip r:embed="rId10"/>
          <a:srcRect l="9281"/>
          <a:stretch>
            <a:fillRect/>
          </a:stretch>
        </p:blipFill>
        <p:spPr>
          <a:xfrm>
            <a:off x="10935801" y="320815"/>
            <a:ext cx="1131041" cy="1985855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15C13838-C665-B0ED-2986-5D09ACC4142D}"/>
              </a:ext>
            </a:extLst>
          </p:cNvPr>
          <p:cNvSpPr txBox="1"/>
          <p:nvPr/>
        </p:nvSpPr>
        <p:spPr>
          <a:xfrm>
            <a:off x="368158" y="12937"/>
            <a:ext cx="676788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dirty="0">
                <a:latin typeface="Arial" panose="020B0604020202020204" pitchFamily="34" charset="0"/>
                <a:cs typeface="Arial" panose="020B0604020202020204" pitchFamily="34" charset="0"/>
              </a:rPr>
              <a:t>1 month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E3F3E172-4F0B-A85D-7E44-9F144A321DF1}"/>
              </a:ext>
            </a:extLst>
          </p:cNvPr>
          <p:cNvSpPr txBox="1"/>
          <p:nvPr/>
        </p:nvSpPr>
        <p:spPr>
          <a:xfrm>
            <a:off x="1541739" y="12936"/>
            <a:ext cx="790601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dirty="0">
                <a:latin typeface="Arial" panose="020B0604020202020204" pitchFamily="34" charset="0"/>
                <a:cs typeface="Arial" panose="020B0604020202020204" pitchFamily="34" charset="0"/>
              </a:rPr>
              <a:t>1.5 month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320FA1AC-B24E-B2D2-1F29-0F60AAFFA014}"/>
              </a:ext>
            </a:extLst>
          </p:cNvPr>
          <p:cNvSpPr txBox="1"/>
          <p:nvPr/>
        </p:nvSpPr>
        <p:spPr>
          <a:xfrm>
            <a:off x="2853042" y="8077"/>
            <a:ext cx="745717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dirty="0">
                <a:latin typeface="Arial" panose="020B0604020202020204" pitchFamily="34" charset="0"/>
                <a:cs typeface="Arial" panose="020B0604020202020204" pitchFamily="34" charset="0"/>
              </a:rPr>
              <a:t>2 months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A379827F-2008-1459-2AEA-5189E61F0696}"/>
              </a:ext>
            </a:extLst>
          </p:cNvPr>
          <p:cNvSpPr txBox="1"/>
          <p:nvPr/>
        </p:nvSpPr>
        <p:spPr>
          <a:xfrm>
            <a:off x="4442904" y="23774"/>
            <a:ext cx="676788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dirty="0">
                <a:latin typeface="Arial" panose="020B0604020202020204" pitchFamily="34" charset="0"/>
                <a:cs typeface="Arial" panose="020B0604020202020204" pitchFamily="34" charset="0"/>
              </a:rPr>
              <a:t>1 month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8DC7446D-5BF5-6459-DB1A-EF0776621287}"/>
              </a:ext>
            </a:extLst>
          </p:cNvPr>
          <p:cNvSpPr txBox="1"/>
          <p:nvPr/>
        </p:nvSpPr>
        <p:spPr>
          <a:xfrm>
            <a:off x="5616483" y="23773"/>
            <a:ext cx="790601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dirty="0">
                <a:latin typeface="Arial" panose="020B0604020202020204" pitchFamily="34" charset="0"/>
                <a:cs typeface="Arial" panose="020B0604020202020204" pitchFamily="34" charset="0"/>
              </a:rPr>
              <a:t>1.5 month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565528DC-F9A3-846C-1FAF-571B54A78DC9}"/>
              </a:ext>
            </a:extLst>
          </p:cNvPr>
          <p:cNvSpPr txBox="1"/>
          <p:nvPr/>
        </p:nvSpPr>
        <p:spPr>
          <a:xfrm>
            <a:off x="6927787" y="18914"/>
            <a:ext cx="745717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dirty="0">
                <a:latin typeface="Arial" panose="020B0604020202020204" pitchFamily="34" charset="0"/>
                <a:cs typeface="Arial" panose="020B0604020202020204" pitchFamily="34" charset="0"/>
              </a:rPr>
              <a:t>2 months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B9760F66-290C-7C87-EF0B-4BDF9B6EA093}"/>
              </a:ext>
            </a:extLst>
          </p:cNvPr>
          <p:cNvSpPr txBox="1"/>
          <p:nvPr/>
        </p:nvSpPr>
        <p:spPr>
          <a:xfrm>
            <a:off x="8672922" y="33435"/>
            <a:ext cx="676788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dirty="0">
                <a:latin typeface="Arial" panose="020B0604020202020204" pitchFamily="34" charset="0"/>
                <a:cs typeface="Arial" panose="020B0604020202020204" pitchFamily="34" charset="0"/>
              </a:rPr>
              <a:t>1 month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8CE42C33-F7FC-376D-CA24-D16E3F79300D}"/>
              </a:ext>
            </a:extLst>
          </p:cNvPr>
          <p:cNvSpPr txBox="1"/>
          <p:nvPr/>
        </p:nvSpPr>
        <p:spPr>
          <a:xfrm>
            <a:off x="9846503" y="33434"/>
            <a:ext cx="790601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dirty="0">
                <a:latin typeface="Arial" panose="020B0604020202020204" pitchFamily="34" charset="0"/>
                <a:cs typeface="Arial" panose="020B0604020202020204" pitchFamily="34" charset="0"/>
              </a:rPr>
              <a:t>1.5 month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7B4C5746-F617-7619-59D5-44A359023A0E}"/>
              </a:ext>
            </a:extLst>
          </p:cNvPr>
          <p:cNvSpPr txBox="1"/>
          <p:nvPr/>
        </p:nvSpPr>
        <p:spPr>
          <a:xfrm>
            <a:off x="11157805" y="28575"/>
            <a:ext cx="745717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dirty="0">
                <a:latin typeface="Arial" panose="020B0604020202020204" pitchFamily="34" charset="0"/>
                <a:cs typeface="Arial" panose="020B0604020202020204" pitchFamily="34" charset="0"/>
              </a:rPr>
              <a:t>2 months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1231F905-5C94-417D-034A-31CEA3F29042}"/>
              </a:ext>
            </a:extLst>
          </p:cNvPr>
          <p:cNvSpPr txBox="1"/>
          <p:nvPr/>
        </p:nvSpPr>
        <p:spPr>
          <a:xfrm>
            <a:off x="-62903" y="6379034"/>
            <a:ext cx="12221088" cy="1677382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algn="just"/>
            <a:r>
              <a:rPr lang="en-US" sz="13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2. </a:t>
            </a:r>
            <a:r>
              <a:rPr lang="en-US" sz="13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 - C) Relative mRNA expression of 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CCNB1, CCNB2 and CDK1 in motor neurons differentiated from </a:t>
            </a:r>
            <a:r>
              <a:rPr lang="en-US" sz="1300" i="1" dirty="0">
                <a:latin typeface="Arial" panose="020B0604020202020204" pitchFamily="34" charset="0"/>
                <a:cs typeface="Arial" panose="020B0604020202020204" pitchFamily="34" charset="0"/>
              </a:rPr>
              <a:t>C9orf72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homozygous and heterozygous knock out lines compared to their parental line. (D) (E-K) mRNA levels of CDK4 in control iPSC-derived motor neurons treated with poly (PR) (1 and 2 µM). (E-K) mRNA levels of Ki67, GMNN, CCNA2, CCNB2, CCND2, CCNE1 and CDK1 in control iPSC-derived motor neurons treated with poly (GR) (1 and 2 µM).</a:t>
            </a:r>
          </a:p>
          <a:p>
            <a:pPr algn="just"/>
            <a:endParaRPr lang="en-US" sz="1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3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ata presented in (D-G) is from 3 independent differentiation experiments of control parental iPSC lines and</a:t>
            </a:r>
            <a:r>
              <a:rPr lang="en-US" sz="1300" i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9orf72 </a:t>
            </a:r>
            <a:r>
              <a:rPr lang="en-US" sz="13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eterozygous and homozygous Knockout lines. Two-tailed t-test with Welch’s correction was applied. ns, not significant.</a:t>
            </a:r>
            <a:r>
              <a:rPr lang="en-US" sz="13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3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ata in (E and K) is from </a:t>
            </a:r>
            <a:r>
              <a:rPr lang="en-US" sz="13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 control iPSC lines from 3 independent differentiation experiments. Two-tailed t-test with Welch’s correction was applied. ns, not significant, </a:t>
            </a:r>
            <a:r>
              <a:rPr lang="en-US" sz="13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nd **p&lt;0.01. </a:t>
            </a:r>
            <a:endParaRPr lang="en-US" sz="13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just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5113CA6-A0C7-AA0D-703A-15FEBA86DB96}"/>
              </a:ext>
            </a:extLst>
          </p:cNvPr>
          <p:cNvSpPr txBox="1"/>
          <p:nvPr/>
        </p:nvSpPr>
        <p:spPr>
          <a:xfrm>
            <a:off x="33927" y="-45784"/>
            <a:ext cx="303288" cy="2893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8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E040334-3F46-4ECB-253A-A3380B44A955}"/>
              </a:ext>
            </a:extLst>
          </p:cNvPr>
          <p:cNvSpPr txBox="1"/>
          <p:nvPr/>
        </p:nvSpPr>
        <p:spPr>
          <a:xfrm>
            <a:off x="4011695" y="-47249"/>
            <a:ext cx="303288" cy="2893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8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2CCEB43-EC5F-7FE3-B2B6-2FB4A8281868}"/>
              </a:ext>
            </a:extLst>
          </p:cNvPr>
          <p:cNvSpPr txBox="1"/>
          <p:nvPr/>
        </p:nvSpPr>
        <p:spPr>
          <a:xfrm>
            <a:off x="8250681" y="-38859"/>
            <a:ext cx="303288" cy="2893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8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71F820A-1111-04C0-BCA7-B3D631AFE6BC}"/>
              </a:ext>
            </a:extLst>
          </p:cNvPr>
          <p:cNvSpPr txBox="1"/>
          <p:nvPr/>
        </p:nvSpPr>
        <p:spPr>
          <a:xfrm>
            <a:off x="5096947" y="2148540"/>
            <a:ext cx="303288" cy="2893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8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52CA981-A02B-C4FC-8FA4-1E65FB607D6F}"/>
              </a:ext>
            </a:extLst>
          </p:cNvPr>
          <p:cNvSpPr txBox="1"/>
          <p:nvPr/>
        </p:nvSpPr>
        <p:spPr>
          <a:xfrm>
            <a:off x="190926" y="4175609"/>
            <a:ext cx="293670" cy="2893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8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3365C562-17EC-9206-97CC-E61D0E5BECB1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541796" y="4280217"/>
            <a:ext cx="1692095" cy="1755648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434C0B98-47BC-30D5-1897-A7532602FB4B}"/>
              </a:ext>
            </a:extLst>
          </p:cNvPr>
          <p:cNvSpPr txBox="1"/>
          <p:nvPr/>
        </p:nvSpPr>
        <p:spPr>
          <a:xfrm>
            <a:off x="916229" y="6046705"/>
            <a:ext cx="931665" cy="2400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0" dirty="0">
                <a:latin typeface="Arial" panose="020B0604020202020204" pitchFamily="34" charset="0"/>
                <a:cs typeface="Arial" panose="020B0604020202020204" pitchFamily="34" charset="0"/>
              </a:rPr>
              <a:t>Poly GR (µM)</a:t>
            </a:r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0326065D-0596-F7B6-7C30-6F8EA1FACFF0}"/>
              </a:ext>
            </a:extLst>
          </p:cNvPr>
          <p:cNvCxnSpPr>
            <a:cxnSpLocks/>
          </p:cNvCxnSpPr>
          <p:nvPr/>
        </p:nvCxnSpPr>
        <p:spPr>
          <a:xfrm>
            <a:off x="1017017" y="6046705"/>
            <a:ext cx="726099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41" name="Picture 40">
            <a:extLst>
              <a:ext uri="{FF2B5EF4-FFF2-40B4-BE49-F238E27FC236}">
                <a16:creationId xmlns:a16="http://schemas.microsoft.com/office/drawing/2014/main" id="{88805ECC-FF9F-7F9C-0D6D-34290DA45DAA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153017" y="4271615"/>
            <a:ext cx="1789249" cy="1755648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A817BFCB-7A58-35A1-960F-2C7D4EF89B91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32747" y="4296967"/>
            <a:ext cx="1747406" cy="1755648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7B90FA0E-2960-CD8E-F6AC-978DA9658BD3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905376" y="4280761"/>
            <a:ext cx="1723136" cy="1755648"/>
          </a:xfrm>
          <a:prstGeom prst="rect">
            <a:avLst/>
          </a:prstGeom>
        </p:spPr>
      </p:pic>
      <p:pic>
        <p:nvPicPr>
          <p:cNvPr id="44" name="Picture 43">
            <a:extLst>
              <a:ext uri="{FF2B5EF4-FFF2-40B4-BE49-F238E27FC236}">
                <a16:creationId xmlns:a16="http://schemas.microsoft.com/office/drawing/2014/main" id="{48930002-78AA-E13B-1C4C-4D51FE2CE687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0259795" y="4287382"/>
            <a:ext cx="1833102" cy="1755648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B180EA9D-52AC-48ED-8D42-DEE8112977D2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6893280" y="4268946"/>
            <a:ext cx="1755648" cy="1755648"/>
          </a:xfrm>
          <a:prstGeom prst="rect">
            <a:avLst/>
          </a:prstGeom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76099EB4-DE4C-361C-1ABB-CB7FD8CB843A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8558110" y="4274103"/>
            <a:ext cx="1805809" cy="1755648"/>
          </a:xfrm>
          <a:prstGeom prst="rect">
            <a:avLst/>
          </a:prstGeom>
        </p:spPr>
      </p:pic>
      <p:sp>
        <p:nvSpPr>
          <p:cNvPr id="47" name="TextBox 46">
            <a:extLst>
              <a:ext uri="{FF2B5EF4-FFF2-40B4-BE49-F238E27FC236}">
                <a16:creationId xmlns:a16="http://schemas.microsoft.com/office/drawing/2014/main" id="{992D8309-C612-E976-A2B1-1812EE712740}"/>
              </a:ext>
            </a:extLst>
          </p:cNvPr>
          <p:cNvSpPr txBox="1"/>
          <p:nvPr/>
        </p:nvSpPr>
        <p:spPr>
          <a:xfrm>
            <a:off x="2559633" y="6046705"/>
            <a:ext cx="931665" cy="2400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0" dirty="0">
                <a:latin typeface="Arial" panose="020B0604020202020204" pitchFamily="34" charset="0"/>
                <a:cs typeface="Arial" panose="020B0604020202020204" pitchFamily="34" charset="0"/>
              </a:rPr>
              <a:t>Poly GR (µM)</a:t>
            </a:r>
          </a:p>
        </p:txBody>
      </p: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86E469AD-0E8B-55E3-9BFD-63BA4427339F}"/>
              </a:ext>
            </a:extLst>
          </p:cNvPr>
          <p:cNvCxnSpPr>
            <a:cxnSpLocks/>
          </p:cNvCxnSpPr>
          <p:nvPr/>
        </p:nvCxnSpPr>
        <p:spPr>
          <a:xfrm>
            <a:off x="2660421" y="6046705"/>
            <a:ext cx="726099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456301A5-AF22-48C6-BC2F-626314B7F15E}"/>
              </a:ext>
            </a:extLst>
          </p:cNvPr>
          <p:cNvSpPr txBox="1"/>
          <p:nvPr/>
        </p:nvSpPr>
        <p:spPr>
          <a:xfrm>
            <a:off x="4215898" y="6042990"/>
            <a:ext cx="931665" cy="2400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0" dirty="0">
                <a:latin typeface="Arial" panose="020B0604020202020204" pitchFamily="34" charset="0"/>
                <a:cs typeface="Arial" panose="020B0604020202020204" pitchFamily="34" charset="0"/>
              </a:rPr>
              <a:t>Poly GR (µM)</a:t>
            </a: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C92C315D-006C-5D97-1A5C-D22D2CCBC6CC}"/>
              </a:ext>
            </a:extLst>
          </p:cNvPr>
          <p:cNvCxnSpPr>
            <a:cxnSpLocks/>
          </p:cNvCxnSpPr>
          <p:nvPr/>
        </p:nvCxnSpPr>
        <p:spPr>
          <a:xfrm>
            <a:off x="4316687" y="6042990"/>
            <a:ext cx="726099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717F8257-EAD2-C610-FA54-EB69C5AD1914}"/>
              </a:ext>
            </a:extLst>
          </p:cNvPr>
          <p:cNvSpPr txBox="1"/>
          <p:nvPr/>
        </p:nvSpPr>
        <p:spPr>
          <a:xfrm>
            <a:off x="5853867" y="6042990"/>
            <a:ext cx="931665" cy="2400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0" dirty="0">
                <a:latin typeface="Arial" panose="020B0604020202020204" pitchFamily="34" charset="0"/>
                <a:cs typeface="Arial" panose="020B0604020202020204" pitchFamily="34" charset="0"/>
              </a:rPr>
              <a:t>Poly GR (µM)</a:t>
            </a:r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8B63B852-09B4-72D0-719C-15A822F877AC}"/>
              </a:ext>
            </a:extLst>
          </p:cNvPr>
          <p:cNvCxnSpPr>
            <a:cxnSpLocks/>
          </p:cNvCxnSpPr>
          <p:nvPr/>
        </p:nvCxnSpPr>
        <p:spPr>
          <a:xfrm>
            <a:off x="5954655" y="6042990"/>
            <a:ext cx="726099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id="{8C63D5DE-1E49-D69D-173E-4940CF944570}"/>
              </a:ext>
            </a:extLst>
          </p:cNvPr>
          <p:cNvSpPr txBox="1"/>
          <p:nvPr/>
        </p:nvSpPr>
        <p:spPr>
          <a:xfrm>
            <a:off x="7597696" y="6037524"/>
            <a:ext cx="931665" cy="2400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0" dirty="0">
                <a:latin typeface="Arial" panose="020B0604020202020204" pitchFamily="34" charset="0"/>
                <a:cs typeface="Arial" panose="020B0604020202020204" pitchFamily="34" charset="0"/>
              </a:rPr>
              <a:t>Poly GR (µM)</a:t>
            </a:r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E80A3D60-4605-6240-C9B7-3129308ACC5B}"/>
              </a:ext>
            </a:extLst>
          </p:cNvPr>
          <p:cNvCxnSpPr>
            <a:cxnSpLocks/>
          </p:cNvCxnSpPr>
          <p:nvPr/>
        </p:nvCxnSpPr>
        <p:spPr>
          <a:xfrm>
            <a:off x="7698484" y="6037523"/>
            <a:ext cx="726099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A0C57061-4960-1417-E866-49049444B5DD}"/>
              </a:ext>
            </a:extLst>
          </p:cNvPr>
          <p:cNvSpPr txBox="1"/>
          <p:nvPr/>
        </p:nvSpPr>
        <p:spPr>
          <a:xfrm>
            <a:off x="9368153" y="6037524"/>
            <a:ext cx="931665" cy="2400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0" dirty="0">
                <a:latin typeface="Arial" panose="020B0604020202020204" pitchFamily="34" charset="0"/>
                <a:cs typeface="Arial" panose="020B0604020202020204" pitchFamily="34" charset="0"/>
              </a:rPr>
              <a:t>Poly GR (µM)</a:t>
            </a:r>
          </a:p>
        </p:txBody>
      </p: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C71CA60A-38EA-4370-7791-AE9D175A47A1}"/>
              </a:ext>
            </a:extLst>
          </p:cNvPr>
          <p:cNvCxnSpPr>
            <a:cxnSpLocks/>
          </p:cNvCxnSpPr>
          <p:nvPr/>
        </p:nvCxnSpPr>
        <p:spPr>
          <a:xfrm>
            <a:off x="9468941" y="6037523"/>
            <a:ext cx="726099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id="{6026C481-AB8A-DF8B-40A3-28174E1B9D78}"/>
              </a:ext>
            </a:extLst>
          </p:cNvPr>
          <p:cNvSpPr txBox="1"/>
          <p:nvPr/>
        </p:nvSpPr>
        <p:spPr>
          <a:xfrm>
            <a:off x="11020301" y="6042015"/>
            <a:ext cx="931665" cy="2400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0" dirty="0">
                <a:latin typeface="Arial" panose="020B0604020202020204" pitchFamily="34" charset="0"/>
                <a:cs typeface="Arial" panose="020B0604020202020204" pitchFamily="34" charset="0"/>
              </a:rPr>
              <a:t>Poly GR (µM)</a:t>
            </a:r>
          </a:p>
        </p:txBody>
      </p: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9B014348-B2B0-8A53-2E10-9D97489DD0E9}"/>
              </a:ext>
            </a:extLst>
          </p:cNvPr>
          <p:cNvCxnSpPr>
            <a:cxnSpLocks/>
          </p:cNvCxnSpPr>
          <p:nvPr/>
        </p:nvCxnSpPr>
        <p:spPr>
          <a:xfrm>
            <a:off x="11121089" y="6052175"/>
            <a:ext cx="726099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id="{F68EF770-177E-9BF8-5AD2-DC09052ED08F}"/>
              </a:ext>
            </a:extLst>
          </p:cNvPr>
          <p:cNvSpPr txBox="1"/>
          <p:nvPr/>
        </p:nvSpPr>
        <p:spPr>
          <a:xfrm>
            <a:off x="1838085" y="4182839"/>
            <a:ext cx="285656" cy="2893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8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405B90D6-B924-4FDF-73B6-A1EC969C1CDD}"/>
              </a:ext>
            </a:extLst>
          </p:cNvPr>
          <p:cNvSpPr txBox="1"/>
          <p:nvPr/>
        </p:nvSpPr>
        <p:spPr>
          <a:xfrm>
            <a:off x="3495971" y="4172679"/>
            <a:ext cx="312906" cy="2893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8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62552781-282D-E585-4F2F-206DC0C7E9DD}"/>
              </a:ext>
            </a:extLst>
          </p:cNvPr>
          <p:cNvSpPr txBox="1"/>
          <p:nvPr/>
        </p:nvSpPr>
        <p:spPr>
          <a:xfrm>
            <a:off x="5104105" y="4186881"/>
            <a:ext cx="303288" cy="2893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8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CF7B5403-8BE6-FB46-9772-272E7782BC76}"/>
              </a:ext>
            </a:extLst>
          </p:cNvPr>
          <p:cNvSpPr txBox="1"/>
          <p:nvPr/>
        </p:nvSpPr>
        <p:spPr>
          <a:xfrm>
            <a:off x="6853486" y="4194046"/>
            <a:ext cx="229550" cy="2893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8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195D8890-E227-9D1A-AF83-8F41790C7F51}"/>
              </a:ext>
            </a:extLst>
          </p:cNvPr>
          <p:cNvSpPr txBox="1"/>
          <p:nvPr/>
        </p:nvSpPr>
        <p:spPr>
          <a:xfrm>
            <a:off x="10207516" y="4209212"/>
            <a:ext cx="303288" cy="2893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80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</a:p>
        </p:txBody>
      </p:sp>
      <p:pic>
        <p:nvPicPr>
          <p:cNvPr id="67" name="Picture 66">
            <a:extLst>
              <a:ext uri="{FF2B5EF4-FFF2-40B4-BE49-F238E27FC236}">
                <a16:creationId xmlns:a16="http://schemas.microsoft.com/office/drawing/2014/main" id="{509CB380-8907-A8A0-E4BF-5EC86E6B0A40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5150848" y="2264526"/>
            <a:ext cx="1874519" cy="1755648"/>
          </a:xfrm>
          <a:prstGeom prst="rect">
            <a:avLst/>
          </a:prstGeom>
        </p:spPr>
      </p:pic>
      <p:sp>
        <p:nvSpPr>
          <p:cNvPr id="69" name="TextBox 68">
            <a:extLst>
              <a:ext uri="{FF2B5EF4-FFF2-40B4-BE49-F238E27FC236}">
                <a16:creationId xmlns:a16="http://schemas.microsoft.com/office/drawing/2014/main" id="{37FF4674-9225-7441-A762-7CBD4C7AD4AD}"/>
              </a:ext>
            </a:extLst>
          </p:cNvPr>
          <p:cNvSpPr txBox="1"/>
          <p:nvPr/>
        </p:nvSpPr>
        <p:spPr>
          <a:xfrm>
            <a:off x="8504768" y="4203711"/>
            <a:ext cx="276038" cy="2893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8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61356A89-3B7E-3981-6A24-8662D8505A72}"/>
              </a:ext>
            </a:extLst>
          </p:cNvPr>
          <p:cNvSpPr txBox="1"/>
          <p:nvPr/>
        </p:nvSpPr>
        <p:spPr>
          <a:xfrm>
            <a:off x="5892723" y="4031935"/>
            <a:ext cx="917239" cy="2400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0" dirty="0">
                <a:latin typeface="Arial" panose="020B0604020202020204" pitchFamily="34" charset="0"/>
                <a:cs typeface="Arial" panose="020B0604020202020204" pitchFamily="34" charset="0"/>
              </a:rPr>
              <a:t>Poly PR (µM)</a:t>
            </a:r>
          </a:p>
        </p:txBody>
      </p: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DCFD1E5B-A399-5A87-7F5B-7F1A693AC8F9}"/>
              </a:ext>
            </a:extLst>
          </p:cNvPr>
          <p:cNvCxnSpPr>
            <a:cxnSpLocks/>
          </p:cNvCxnSpPr>
          <p:nvPr/>
        </p:nvCxnSpPr>
        <p:spPr>
          <a:xfrm>
            <a:off x="5967842" y="4012681"/>
            <a:ext cx="726099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612294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3C6DDDC2-3FE8-1228-AB96-6F0AA09A064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25729" y="406868"/>
            <a:ext cx="2030971" cy="2361004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292340DB-5014-3932-9391-615CE2F3830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51039" y="496807"/>
            <a:ext cx="2145213" cy="2259455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360A9153-CA66-07F9-E857-37DD3000A01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93133" y="3442127"/>
            <a:ext cx="2157907" cy="2259456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BF44B34D-E16D-1434-EB63-1084BEF6D91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492444" y="509656"/>
            <a:ext cx="2157907" cy="2272149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174ED514-5C80-FED2-C0A3-CB9C7D43B9C3}"/>
              </a:ext>
            </a:extLst>
          </p:cNvPr>
          <p:cNvSpPr txBox="1"/>
          <p:nvPr/>
        </p:nvSpPr>
        <p:spPr>
          <a:xfrm>
            <a:off x="3150267" y="2785169"/>
            <a:ext cx="1157689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dirty="0">
                <a:latin typeface="Arial" panose="020B0604020202020204" pitchFamily="34" charset="0"/>
                <a:cs typeface="Arial" panose="020B0604020202020204" pitchFamily="34" charset="0"/>
              </a:rPr>
              <a:t>Palbociclib (µM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937B3D5-B53D-5151-3B2B-C3577D7385F3}"/>
              </a:ext>
            </a:extLst>
          </p:cNvPr>
          <p:cNvSpPr txBox="1"/>
          <p:nvPr/>
        </p:nvSpPr>
        <p:spPr>
          <a:xfrm>
            <a:off x="5416734" y="2785169"/>
            <a:ext cx="1157689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dirty="0">
                <a:latin typeface="Arial" panose="020B0604020202020204" pitchFamily="34" charset="0"/>
                <a:cs typeface="Arial" panose="020B0604020202020204" pitchFamily="34" charset="0"/>
              </a:rPr>
              <a:t>Palbociclib (µM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38CC621-98EB-0F8F-E52F-5DD03ED65523}"/>
              </a:ext>
            </a:extLst>
          </p:cNvPr>
          <p:cNvSpPr txBox="1"/>
          <p:nvPr/>
        </p:nvSpPr>
        <p:spPr>
          <a:xfrm>
            <a:off x="7657436" y="2785169"/>
            <a:ext cx="1157689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dirty="0">
                <a:latin typeface="Arial" panose="020B0604020202020204" pitchFamily="34" charset="0"/>
                <a:cs typeface="Arial" panose="020B0604020202020204" pitchFamily="34" charset="0"/>
              </a:rPr>
              <a:t>Palbociclib (µM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988ADFD-6E45-2E9A-7134-B002B10F4C09}"/>
              </a:ext>
            </a:extLst>
          </p:cNvPr>
          <p:cNvSpPr txBox="1"/>
          <p:nvPr/>
        </p:nvSpPr>
        <p:spPr>
          <a:xfrm>
            <a:off x="5477549" y="5723852"/>
            <a:ext cx="1157689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dirty="0">
                <a:latin typeface="Arial" panose="020B0604020202020204" pitchFamily="34" charset="0"/>
                <a:cs typeface="Arial" panose="020B0604020202020204" pitchFamily="34" charset="0"/>
              </a:rPr>
              <a:t>Palbociclib (µM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52AA09F-BE3D-5802-CEE6-361BD8A5F445}"/>
              </a:ext>
            </a:extLst>
          </p:cNvPr>
          <p:cNvSpPr txBox="1"/>
          <p:nvPr/>
        </p:nvSpPr>
        <p:spPr>
          <a:xfrm>
            <a:off x="0" y="6187824"/>
            <a:ext cx="12192000" cy="1120435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3: 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lative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RNA levels of GMNN, CCNB2, CCNE2, and CDK2 in 2-month-old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C9orf72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iPSC-derived motor neurons treated with Palbociclib 1 and 5 µM.</a:t>
            </a:r>
          </a:p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Data is from 2 </a:t>
            </a:r>
            <a:r>
              <a:rPr lang="en-US" sz="14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C9orf72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iPSC lines from 3 independent experiments. Two-tailed t-test with Welch’s correction was applied *p&lt;0.05. </a:t>
            </a:r>
            <a:endParaRPr lang="en-US" sz="14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/>
            <a:r>
              <a:rPr lang="en-US" sz="1081" b="1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1071678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oup of colorful lines&#10;&#10;AI-generated content may be incorrect.">
            <a:extLst>
              <a:ext uri="{FF2B5EF4-FFF2-40B4-BE49-F238E27FC236}">
                <a16:creationId xmlns:a16="http://schemas.microsoft.com/office/drawing/2014/main" id="{5E4FBD7D-1ED8-A66C-A779-5217F8E252AE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5805" t="8619" r="31122" b="7312"/>
          <a:stretch/>
        </p:blipFill>
        <p:spPr>
          <a:xfrm>
            <a:off x="3801630" y="3138055"/>
            <a:ext cx="4320748" cy="3849837"/>
          </a:xfrm>
          <a:prstGeom prst="rect">
            <a:avLst/>
          </a:prstGeom>
        </p:spPr>
      </p:pic>
      <p:pic>
        <p:nvPicPr>
          <p:cNvPr id="5" name="Picture 4" descr="A diagram of a diagram of a person's body&#10;&#10;AI-generated content may be incorrect.">
            <a:extLst>
              <a:ext uri="{FF2B5EF4-FFF2-40B4-BE49-F238E27FC236}">
                <a16:creationId xmlns:a16="http://schemas.microsoft.com/office/drawing/2014/main" id="{D4549A4B-7E0C-9FF2-C25E-C9DF93EE2E89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7841" t="10541" r="13324" b="18701"/>
          <a:stretch/>
        </p:blipFill>
        <p:spPr>
          <a:xfrm>
            <a:off x="2767666" y="0"/>
            <a:ext cx="6388677" cy="322541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775BA08-7211-E689-D20F-5C4FB7BA00ED}"/>
              </a:ext>
            </a:extLst>
          </p:cNvPr>
          <p:cNvSpPr txBox="1"/>
          <p:nvPr/>
        </p:nvSpPr>
        <p:spPr>
          <a:xfrm>
            <a:off x="2464378" y="0"/>
            <a:ext cx="303288" cy="2893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8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8E9DF73-EE88-6062-30ED-E90C8039688C}"/>
              </a:ext>
            </a:extLst>
          </p:cNvPr>
          <p:cNvSpPr txBox="1"/>
          <p:nvPr/>
        </p:nvSpPr>
        <p:spPr>
          <a:xfrm>
            <a:off x="3575279" y="3163543"/>
            <a:ext cx="303288" cy="2893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8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857B648-04E5-74E6-4A45-A5FDE5828447}"/>
              </a:ext>
            </a:extLst>
          </p:cNvPr>
          <p:cNvSpPr txBox="1"/>
          <p:nvPr/>
        </p:nvSpPr>
        <p:spPr>
          <a:xfrm>
            <a:off x="0" y="7169245"/>
            <a:ext cx="1219200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400" kern="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(A) UMAP plot of single-nucleus RNA sequencing data from excitatory neurons C9orf72 ALS and </a:t>
            </a:r>
            <a:r>
              <a:rPr lang="en-US" sz="1400" kern="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control </a:t>
            </a:r>
            <a:r>
              <a:rPr lang="en-US" sz="1400" kern="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groups. </a:t>
            </a:r>
            <a:r>
              <a:rPr lang="en-US" sz="1400" kern="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(B) </a:t>
            </a:r>
            <a:r>
              <a:rPr lang="en-US" sz="1400" b="0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he density and distribution of -log10(p-values) (y-axis) within each subcluster illustrates the variability and statistical significance of cell cycle scores relative to other subclusters.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3063160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60765C56-978A-8B22-C0A8-D8E6890604A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29794293"/>
              </p:ext>
            </p:extLst>
          </p:nvPr>
        </p:nvGraphicFramePr>
        <p:xfrm>
          <a:off x="3438817" y="1210837"/>
          <a:ext cx="5314366" cy="4269499"/>
        </p:xfrm>
        <a:graphic>
          <a:graphicData uri="http://schemas.openxmlformats.org/drawingml/2006/table">
            <a:tbl>
              <a:tblPr firstRow="1" firstCol="1" bandRow="1"/>
              <a:tblGrid>
                <a:gridCol w="1173708">
                  <a:extLst>
                    <a:ext uri="{9D8B030D-6E8A-4147-A177-3AD203B41FA5}">
                      <a16:colId xmlns:a16="http://schemas.microsoft.com/office/drawing/2014/main" val="695806452"/>
                    </a:ext>
                  </a:extLst>
                </a:gridCol>
                <a:gridCol w="2097327">
                  <a:extLst>
                    <a:ext uri="{9D8B030D-6E8A-4147-A177-3AD203B41FA5}">
                      <a16:colId xmlns:a16="http://schemas.microsoft.com/office/drawing/2014/main" val="3843377390"/>
                    </a:ext>
                  </a:extLst>
                </a:gridCol>
                <a:gridCol w="2043331">
                  <a:extLst>
                    <a:ext uri="{9D8B030D-6E8A-4147-A177-3AD203B41FA5}">
                      <a16:colId xmlns:a16="http://schemas.microsoft.com/office/drawing/2014/main" val="4225773572"/>
                    </a:ext>
                  </a:extLst>
                </a:gridCol>
              </a:tblGrid>
              <a:tr h="194253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argeted genes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orward primers (5’ to 3’)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verse primer (5’ to 3’)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5594936"/>
                  </a:ext>
                </a:extLst>
              </a:tr>
              <a:tr h="194253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Ki67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TTGGGTGCGACTTGACGA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  <a:tabLst>
                          <a:tab pos="605155" algn="l"/>
                        </a:tabLs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CAACTCTTCCACTGGGACG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60589606"/>
                  </a:ext>
                </a:extLst>
              </a:tr>
              <a:tr h="230224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MNN</a:t>
                      </a:r>
                      <a:endParaRPr lang="en-US" sz="7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TCAGTTGGTCACGTGGTTG</a:t>
                      </a:r>
                      <a:endParaRPr lang="en-US" sz="7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GAAGCACAGAAGATGGGTGG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27700113"/>
                  </a:ext>
                </a:extLst>
              </a:tr>
              <a:tr h="247921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CNA2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CTACACAGTCACGGGACAAAG</a:t>
                      </a:r>
                      <a:endParaRPr lang="en-US" sz="7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  <a:tabLst>
                          <a:tab pos="734060" algn="l"/>
                        </a:tabLs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GTGGTGCTTTGAGGTAGGTC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98073749"/>
                  </a:ext>
                </a:extLst>
              </a:tr>
              <a:tr h="257838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CNB1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ACCTGTGTCAGGCTTTCTCTG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  <a:tabLst>
                          <a:tab pos="315595" algn="l"/>
                        </a:tabLs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TATTTTGGTCTGACTGCTTGC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41773043"/>
                  </a:ext>
                </a:extLst>
              </a:tr>
              <a:tr h="194253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CNB2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GGAAAAGTTGGCTCCAAAG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CAGAAAAAGCTTGGCAGAGA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13114693"/>
                  </a:ext>
                </a:extLst>
              </a:tr>
              <a:tr h="22898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CNC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CAGAAAGATGCCAGGCAATGG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CTCATCGAAATTCTTCCACTGC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22186206"/>
                  </a:ext>
                </a:extLst>
              </a:tr>
              <a:tr h="194253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CND1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CTGTGCATCTACACCGACA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TGAGCTTGTTCACCAGGAG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59014949"/>
                  </a:ext>
                </a:extLst>
              </a:tr>
              <a:tr h="194253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CND2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ACATCCAACCCTACATGC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  <a:tabLst>
                          <a:tab pos="309245" algn="l"/>
                        </a:tabLs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CACTTCTGTTCCTCACAG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90973265"/>
                  </a:ext>
                </a:extLst>
              </a:tr>
              <a:tr h="194253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CNE1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CCAAAATCGACAGGAC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GTCTGCACAGACTGCAT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32917261"/>
                  </a:ext>
                </a:extLst>
              </a:tr>
              <a:tr h="221626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CNE2</a:t>
                      </a:r>
                      <a:endParaRPr lang="en-US" sz="7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  <a:tabLst>
                          <a:tab pos="257810" algn="l"/>
                        </a:tabLs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CCATTGATTCATTAGAGTTCCA</a:t>
                      </a:r>
                      <a:endParaRPr lang="en-US" sz="7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GTCCCACTCCAAACCTG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62178102"/>
                  </a:ext>
                </a:extLst>
              </a:tr>
              <a:tr h="220068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K1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AAACCAGGAAGCCTAGCATC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ATGATTCAGTGCCATTTTGCC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79324858"/>
                  </a:ext>
                </a:extLst>
              </a:tr>
              <a:tr h="227656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K2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GGATGCCTCTGCTCTCACTG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CCGATGAGAATGGCAGAAAGC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4691155"/>
                  </a:ext>
                </a:extLst>
              </a:tr>
              <a:tr h="212478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K4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CATCAGCACAGTTCGTGAGGT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CAGTTCGGGATGTGGCACAGA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99763446"/>
                  </a:ext>
                </a:extLst>
              </a:tr>
              <a:tr h="220068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K6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ATAAAGTTCCAGAGCCTGGAG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CGATGCACTACTCGGTGTGAA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61151575"/>
                  </a:ext>
                </a:extLst>
              </a:tr>
              <a:tr h="227656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19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TGCATCCCGACGCCCTCAAC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GGCACCTTGCTTCAGCAGCTC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72151378"/>
                  </a:ext>
                </a:extLst>
              </a:tr>
              <a:tr h="194253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21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GTCAGTTCCTTGTGGAGCC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ACATGGCGCCTCCTCTG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3917930"/>
                  </a:ext>
                </a:extLst>
              </a:tr>
              <a:tr h="194253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OP2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  <a:sym typeface="Symbol" panose="05050102010706020507" pitchFamily="18" charset="2"/>
                        </a:rPr>
                        <a:t>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GTGTCACCATTGCAGCCTGT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ATGTAGGTGTCTGGGCGG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79547271"/>
                  </a:ext>
                </a:extLst>
              </a:tr>
              <a:tr h="42096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APDH</a:t>
                      </a:r>
                      <a:endParaRPr lang="en-US" sz="7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GCACCACCAACTGCTTAGC</a:t>
                      </a:r>
                      <a:endParaRPr lang="en-US" sz="7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CATGGACTGTGGTCATGAG</a:t>
                      </a:r>
                      <a:endParaRPr lang="en-US" sz="7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035" marR="4203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9058170"/>
                  </a:ext>
                </a:extLst>
              </a:tr>
            </a:tbl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0CEE2585-68D2-8116-1A34-E7F6ADD85A28}"/>
              </a:ext>
            </a:extLst>
          </p:cNvPr>
          <p:cNvSpPr txBox="1"/>
          <p:nvPr/>
        </p:nvSpPr>
        <p:spPr>
          <a:xfrm>
            <a:off x="3335976" y="753468"/>
            <a:ext cx="6097136" cy="40517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</a:pPr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 Table 1. List of primers used in this study.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2642943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3394F3C0-9F91-AB2D-C35B-6221195B4E5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57618226"/>
              </p:ext>
            </p:extLst>
          </p:nvPr>
        </p:nvGraphicFramePr>
        <p:xfrm>
          <a:off x="2477670" y="1225762"/>
          <a:ext cx="5937250" cy="2298192"/>
        </p:xfrm>
        <a:graphic>
          <a:graphicData uri="http://schemas.openxmlformats.org/drawingml/2006/table">
            <a:tbl>
              <a:tblPr firstRow="1" firstCol="1" bandRow="1"/>
              <a:tblGrid>
                <a:gridCol w="1482725">
                  <a:extLst>
                    <a:ext uri="{9D8B030D-6E8A-4147-A177-3AD203B41FA5}">
                      <a16:colId xmlns:a16="http://schemas.microsoft.com/office/drawing/2014/main" val="3531642157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3086661842"/>
                    </a:ext>
                  </a:extLst>
                </a:gridCol>
                <a:gridCol w="1057275">
                  <a:extLst>
                    <a:ext uri="{9D8B030D-6E8A-4147-A177-3AD203B41FA5}">
                      <a16:colId xmlns:a16="http://schemas.microsoft.com/office/drawing/2014/main" val="2205990543"/>
                    </a:ext>
                  </a:extLst>
                </a:gridCol>
                <a:gridCol w="1184275">
                  <a:extLst>
                    <a:ext uri="{9D8B030D-6E8A-4147-A177-3AD203B41FA5}">
                      <a16:colId xmlns:a16="http://schemas.microsoft.com/office/drawing/2014/main" val="98313427"/>
                    </a:ext>
                  </a:extLst>
                </a:gridCol>
                <a:gridCol w="1184275">
                  <a:extLst>
                    <a:ext uri="{9D8B030D-6E8A-4147-A177-3AD203B41FA5}">
                      <a16:colId xmlns:a16="http://schemas.microsoft.com/office/drawing/2014/main" val="1342390879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ntibody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endor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talog No.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ource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ilution used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267263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CNA2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ing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7955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abbi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745330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9orf72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ing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2231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abbi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172878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K4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ing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2790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abbi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9068378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opoisomerase II</a:t>
                      </a: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  <a:sym typeface="Symbol" panose="05050102010706020507" pitchFamily="18" charset="2"/>
                        </a:rPr>
                        <a:t>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ing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2286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abbi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2979182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hospho-RB (S780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ing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307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abbi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526039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  <a:sym typeface="Symbol" panose="05050102010706020507" pitchFamily="18" charset="2"/>
                        </a:rPr>
                        <a:t></a:t>
                      </a: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Actin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bclonal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C004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ouse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:10,000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0093418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  <a:sym typeface="Symbol" panose="05050102010706020507" pitchFamily="18" charset="2"/>
                        </a:rPr>
                        <a:t></a:t>
                      </a: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Actin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bclonal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C038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abbi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buNone/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:10,000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35277299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AEB47397-0765-9BE0-777C-879B85C12143}"/>
              </a:ext>
            </a:extLst>
          </p:cNvPr>
          <p:cNvSpPr txBox="1"/>
          <p:nvPr/>
        </p:nvSpPr>
        <p:spPr>
          <a:xfrm>
            <a:off x="2399298" y="768393"/>
            <a:ext cx="6093994" cy="4573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</a:pPr>
            <a:r>
              <a:rPr lang="en-US" sz="14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 Table 2. Antibodies used in this study</a:t>
            </a:r>
            <a:endParaRPr lang="en-US" sz="14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282599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69</TotalTime>
  <Words>620</Words>
  <Application>Microsoft Office PowerPoint</Application>
  <PresentationFormat>Custom</PresentationFormat>
  <Paragraphs>155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Aptos</vt:lpstr>
      <vt:lpstr>Aptos Display</vt:lpstr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li, Sk Imran</dc:creator>
  <cp:lastModifiedBy>Lopez Gonzalez, Rodrigo</cp:lastModifiedBy>
  <cp:revision>15</cp:revision>
  <dcterms:created xsi:type="dcterms:W3CDTF">2025-05-29T13:34:04Z</dcterms:created>
  <dcterms:modified xsi:type="dcterms:W3CDTF">2025-06-01T02:13:42Z</dcterms:modified>
</cp:coreProperties>
</file>